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40FF"/>
    <a:srgbClr val="0432FF"/>
    <a:srgbClr val="0096FF"/>
    <a:srgbClr val="73FB79"/>
    <a:srgbClr val="9437FF"/>
    <a:srgbClr val="00FDFF"/>
    <a:srgbClr val="FFFD78"/>
    <a:srgbClr val="FF2600"/>
    <a:srgbClr val="FF7E79"/>
    <a:srgbClr val="4E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D28AC46-269F-44FE-9C3B-AE79CE7537DE}" v="76" dt="2021-10-03T14:56:41.70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22"/>
    <p:restoredTop sz="94708"/>
  </p:normalViewPr>
  <p:slideViewPr>
    <p:cSldViewPr snapToGrid="0" snapToObjects="1">
      <p:cViewPr varScale="1">
        <p:scale>
          <a:sx n="102" d="100"/>
          <a:sy n="102" d="100"/>
        </p:scale>
        <p:origin x="12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4D28AC46-269F-44FE-9C3B-AE79CE7537DE}"/>
    <pc:docChg chg="undo custSel addSld modSld modMainMaster">
      <pc:chgData name="Lois Hoyer" userId="8c378a1a5b622d94" providerId="LiveId" clId="{4D28AC46-269F-44FE-9C3B-AE79CE7537DE}" dt="2021-10-03T15:00:55.333" v="2622" actId="20577"/>
      <pc:docMkLst>
        <pc:docMk/>
      </pc:docMkLst>
      <pc:sldChg chg="addSp delSp modSp mod">
        <pc:chgData name="Lois Hoyer" userId="8c378a1a5b622d94" providerId="LiveId" clId="{4D28AC46-269F-44FE-9C3B-AE79CE7537DE}" dt="2021-10-03T14:56:41.707" v="2606" actId="338"/>
        <pc:sldMkLst>
          <pc:docMk/>
          <pc:sldMk cId="954159042" sldId="257"/>
        </pc:sldMkLst>
        <pc:spChg chg="add del mod">
          <ac:chgData name="Lois Hoyer" userId="8c378a1a5b622d94" providerId="LiveId" clId="{4D28AC46-269F-44FE-9C3B-AE79CE7537DE}" dt="2021-08-30T14:20:34.411" v="155" actId="478"/>
          <ac:spMkLst>
            <pc:docMk/>
            <pc:sldMk cId="954159042" sldId="257"/>
            <ac:spMk id="2" creationId="{92E6A3FF-B685-4A48-A442-38B9768B0E6A}"/>
          </ac:spMkLst>
        </pc:spChg>
        <pc:spChg chg="add del mod">
          <ac:chgData name="Lois Hoyer" userId="8c378a1a5b622d94" providerId="LiveId" clId="{4D28AC46-269F-44FE-9C3B-AE79CE7537DE}" dt="2021-08-30T14:21:08.788" v="158" actId="478"/>
          <ac:spMkLst>
            <pc:docMk/>
            <pc:sldMk cId="954159042" sldId="257"/>
            <ac:spMk id="3" creationId="{B84A103B-1DF6-4046-AE2B-44B1877EECD9}"/>
          </ac:spMkLst>
        </pc:spChg>
        <pc:spChg chg="add del">
          <ac:chgData name="Lois Hoyer" userId="8c378a1a5b622d94" providerId="LiveId" clId="{4D28AC46-269F-44FE-9C3B-AE79CE7537DE}" dt="2021-08-30T14:21:08.788" v="158" actId="478"/>
          <ac:spMkLst>
            <pc:docMk/>
            <pc:sldMk cId="954159042" sldId="257"/>
            <ac:spMk id="4" creationId="{379045A9-89BE-4564-B1C6-055312194D27}"/>
          </ac:spMkLst>
        </pc:spChg>
        <pc:spChg chg="add mod">
          <ac:chgData name="Lois Hoyer" userId="8c378a1a5b622d94" providerId="LiveId" clId="{4D28AC46-269F-44FE-9C3B-AE79CE7537DE}" dt="2021-09-28T14:08:53.283" v="2591" actId="20577"/>
          <ac:spMkLst>
            <pc:docMk/>
            <pc:sldMk cId="954159042" sldId="257"/>
            <ac:spMk id="5" creationId="{96050657-E3F1-48B8-ACFC-2374102DE33B}"/>
          </ac:spMkLst>
        </pc:spChg>
        <pc:spChg chg="add del mod">
          <ac:chgData name="Lois Hoyer" userId="8c378a1a5b622d94" providerId="LiveId" clId="{4D28AC46-269F-44FE-9C3B-AE79CE7537DE}" dt="2021-09-21T14:08:30.233" v="1653" actId="21"/>
          <ac:spMkLst>
            <pc:docMk/>
            <pc:sldMk cId="954159042" sldId="257"/>
            <ac:spMk id="7" creationId="{567CD372-6159-43D9-AFF4-B6C0CCC9D460}"/>
          </ac:spMkLst>
        </pc:spChg>
        <pc:spChg chg="add del">
          <ac:chgData name="Lois Hoyer" userId="8c378a1a5b622d94" providerId="LiveId" clId="{4D28AC46-269F-44FE-9C3B-AE79CE7537DE}" dt="2021-08-30T14:53:20.801" v="823"/>
          <ac:spMkLst>
            <pc:docMk/>
            <pc:sldMk cId="954159042" sldId="257"/>
            <ac:spMk id="15" creationId="{B0002AC6-57C4-400F-941E-735C1B5C8281}"/>
          </ac:spMkLst>
        </pc:spChg>
        <pc:spChg chg="add del mod">
          <ac:chgData name="Lois Hoyer" userId="8c378a1a5b622d94" providerId="LiveId" clId="{4D28AC46-269F-44FE-9C3B-AE79CE7537DE}" dt="2021-08-30T15:46:53.180" v="1430" actId="478"/>
          <ac:spMkLst>
            <pc:docMk/>
            <pc:sldMk cId="954159042" sldId="257"/>
            <ac:spMk id="18" creationId="{41360FBA-8D41-45D9-BD1D-ED44F6BC5FD3}"/>
          </ac:spMkLst>
        </pc:spChg>
        <pc:spChg chg="add mod">
          <ac:chgData name="Lois Hoyer" userId="8c378a1a5b622d94" providerId="LiveId" clId="{4D28AC46-269F-44FE-9C3B-AE79CE7537DE}" dt="2021-09-21T14:09:00.470" v="1658" actId="1076"/>
          <ac:spMkLst>
            <pc:docMk/>
            <pc:sldMk cId="954159042" sldId="257"/>
            <ac:spMk id="19" creationId="{87AC59A7-4AB2-45F2-9A2C-D24B2A2833F1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0" creationId="{E47BDEE6-1FED-354C-866D-1150E855C0DE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1" creationId="{14088EE7-0D0C-B346-86D2-8863D17A2FAD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2" creationId="{F3D8D4FD-5680-3B40-9747-BEC282B9D564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3" creationId="{E6101CAE-BB8D-EC4E-A376-6DF9167C6660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4" creationId="{6C9A7B49-8001-2448-B367-E979648C0E52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5" creationId="{FF60F57A-41F4-0A46-9196-4712729E387C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6" creationId="{4567C693-5042-464F-9A67-317B5C3A0A8D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7" creationId="{1ACF17DA-E09B-E641-B111-30EE388C3FC2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8" creationId="{E15071A5-0F03-6A46-9E8B-00829A46CDBB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59" creationId="{6BA96F28-2A22-6D42-9CEE-A6DB0C38B0C9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0" creationId="{C3E76E26-5C7D-8848-BB46-5B2E530DCD5C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1" creationId="{F8424D00-05B6-CE4F-BCCE-16CDED4530AE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2" creationId="{87365F4B-0ABB-6343-B0D6-265F7334B295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3" creationId="{91FB8AE8-D5D2-B64A-9C0A-0E8093679156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4" creationId="{E8F7B4BB-5EEB-0B4A-8588-DCC29A320CB8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5" creationId="{051839E9-0386-AB42-A6DF-A5A17026A531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6" creationId="{026A5C82-0419-5140-AAA6-563DADFED43E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7" creationId="{C6435C8B-93BE-384F-A1A6-03657E6953DB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8" creationId="{EF2D7DF4-DFCB-7443-990E-C5D741AB09AA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69" creationId="{181A803C-FAEE-CF40-B340-31C4EE31B1B5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0" creationId="{C9EF19B0-B46A-5C47-9035-E6B9A0C2B353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1" creationId="{81A37607-0604-354D-9EE2-84C9FC55B924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2" creationId="{A80B244B-D767-374D-9E0D-BD4F4B2B6A85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3" creationId="{921C9BD1-E966-BB4F-897B-2E23C26268EF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4" creationId="{B7A2C6DD-64F5-924B-8A11-559C1FF54F24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5" creationId="{CC637010-7190-5D43-9861-9FE9C0B9C637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6" creationId="{0F9A79E5-E715-DF46-94B4-283C75FDF5B5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7" creationId="{0F308568-0608-434B-A937-766A4389557E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8" creationId="{2CCEB257-787F-EA48-8E2C-4B517D5DA5BF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79" creationId="{F9F8D19F-6611-A149-9FDB-2AD22ED6FC74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0" creationId="{D5554AB5-89C4-334C-8587-63F2EE2EC787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1" creationId="{76CB726D-0FF5-E142-8216-B7E957BBEA4F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2" creationId="{816ED7B1-27E2-BD4B-AE4C-62439F9B285D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3" creationId="{C0EB5888-6015-A347-8626-C0078961E8A6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4" creationId="{7BD4F00C-2B22-E64A-96F9-BA6A73143268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5" creationId="{6DEF87D1-6CF1-9340-B95B-B51158692994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6" creationId="{ED460973-2EC4-164C-9230-2E2FC437F608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7" creationId="{A67A168B-CD07-3A4D-9EC6-39232454EF33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8" creationId="{1FA06149-52A1-0E4A-AD9E-246403FB91D3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89" creationId="{D7E45AE7-BE73-6D4C-9C3F-FE825C89CEE0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0" creationId="{A4ACA94D-5710-774D-9FFE-98E5980BA3E5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1" creationId="{434EB71F-528C-2740-9745-8C677E8645E7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2" creationId="{8D7E5192-FDA1-8E49-874E-98D12860A49E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3" creationId="{D1756C9C-093B-6F4B-A1C8-A36277A52F7B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4" creationId="{CF8333CD-E823-9F46-952D-4A9544C8CCB2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5" creationId="{09B71641-662A-1149-900E-6D86F57EE8F1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6" creationId="{0C25A076-CEA7-C947-B00D-7E3AF005DA7F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7" creationId="{E2A48959-0F9F-9546-A9E3-A856EE9B562D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8" creationId="{849546D3-6DBC-F844-9BFB-1C23115AC68A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199" creationId="{38157566-17A3-7549-AC6B-3677850FE057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0" creationId="{BAC4B426-8CB9-F94F-8ED7-CFBA3617F72C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1" creationId="{88F1D954-12FF-0845-987E-A6C951E22953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2" creationId="{BDA7CF03-9241-A840-A6DD-A25FD08E4A2E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3" creationId="{75AE0D25-17EB-FB4F-93AA-77C6F7EC4325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4" creationId="{FEA841B3-43D7-FC42-9278-7D2E854AFC14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5" creationId="{13B0B2E0-EA5C-0946-9D17-9798535E8A40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6" creationId="{2DABDFAF-4A4E-F648-A187-42BE32B71F51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7" creationId="{3C1E6975-E941-6443-872A-6B87291F9BDB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8" creationId="{8B3E10D9-3AA1-A84D-AF8C-8AED47BCB266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09" creationId="{51016769-AF00-9149-ABB2-AB801F073387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10" creationId="{CB809839-FBA7-A34A-889F-6C81E2B50E62}"/>
          </ac:spMkLst>
        </pc:spChg>
        <pc:spChg chg="mod topLvl">
          <ac:chgData name="Lois Hoyer" userId="8c378a1a5b622d94" providerId="LiveId" clId="{4D28AC46-269F-44FE-9C3B-AE79CE7537DE}" dt="2021-10-03T14:56:22.393" v="2604" actId="1582"/>
          <ac:spMkLst>
            <pc:docMk/>
            <pc:sldMk cId="954159042" sldId="257"/>
            <ac:spMk id="211" creationId="{6EC4AA36-0010-124D-9947-18E3D87900FC}"/>
          </ac:spMkLst>
        </pc:spChg>
        <pc:spChg chg="add mod">
          <ac:chgData name="Lois Hoyer" userId="8c378a1a5b622d94" providerId="LiveId" clId="{4D28AC46-269F-44FE-9C3B-AE79CE7537DE}" dt="2021-09-21T14:09:40.801" v="1670" actId="1076"/>
          <ac:spMkLst>
            <pc:docMk/>
            <pc:sldMk cId="954159042" sldId="257"/>
            <ac:spMk id="212" creationId="{2EAFE84B-6625-423B-8EA8-32F570C71C2F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3" creationId="{85D82ECA-64C8-364E-B94A-3E9EB2090B81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4" creationId="{BB3B86EC-4D9B-2D4D-8275-021DC2AE36F2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5" creationId="{F8A78A56-44C0-1543-B7BB-40FC448D493A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6" creationId="{19E874DD-9764-0042-BE1A-3A732A05C200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7" creationId="{575FE7AE-1F2C-AD42-81C0-990EA16BD30A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8" creationId="{61471033-8ADD-AE47-942B-7255AC6C78CE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19" creationId="{508E4FDC-86FD-3841-8F25-E5C77E3BD5C2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0" creationId="{1CD43185-18AF-F54C-A379-C13E28EA963F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1" creationId="{4FFF5BFC-BE96-AA46-AFE3-89F16477E32D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2" creationId="{9BC578EC-8622-FB44-A5AC-C9170AC276CE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3" creationId="{F65B413F-95AC-7443-B13B-471F96D74DFE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4" creationId="{C07241EF-8DD4-FF44-8F99-E9CE27F1A3A8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5" creationId="{D7BCF7AB-F974-6E4C-9E21-9F49BE335C79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6" creationId="{76565A3D-9FD9-5147-95F0-756FB4CF198F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7" creationId="{D3AEA6F3-0062-8248-9A53-95D7E2B3A3E2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8" creationId="{6203B029-4A67-7241-9A4B-9EC4EA617B98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29" creationId="{16676433-C7D9-7B4C-A42E-7F6A4E28D745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30" creationId="{8F5FDF49-CDD7-9F4E-B9E7-E9805977E4E8}"/>
          </ac:spMkLst>
        </pc:spChg>
        <pc:spChg chg="add mod">
          <ac:chgData name="Lois Hoyer" userId="8c378a1a5b622d94" providerId="LiveId" clId="{4D28AC46-269F-44FE-9C3B-AE79CE7537DE}" dt="2021-09-28T14:07:24.170" v="2554" actId="1076"/>
          <ac:spMkLst>
            <pc:docMk/>
            <pc:sldMk cId="954159042" sldId="257"/>
            <ac:spMk id="231" creationId="{2C9BCE71-55BE-4919-9A59-19E92ABE201F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32" creationId="{5714C15C-920D-A44B-AFC5-6FBA20766FD8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33" creationId="{B71E76C7-CB75-1044-8EB6-D3552773A2E5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34" creationId="{AF3BE8F0-B102-1B43-9351-8D93E5A7A09E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235" creationId="{8C7D9870-0076-9340-B162-9902FD580602}"/>
          </ac:spMkLst>
        </pc:spChg>
        <pc:spChg chg="add mod">
          <ac:chgData name="Lois Hoyer" userId="8c378a1a5b622d94" providerId="LiveId" clId="{4D28AC46-269F-44FE-9C3B-AE79CE7537DE}" dt="2021-09-28T14:07:35.477" v="2555" actId="1076"/>
          <ac:spMkLst>
            <pc:docMk/>
            <pc:sldMk cId="954159042" sldId="257"/>
            <ac:spMk id="236" creationId="{C9721E9C-D132-468B-BC09-2D375BE67165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37" creationId="{9C70A6B7-1F0C-5742-9742-950F22DD37AF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38" creationId="{99537C7D-5062-4049-8D27-99736892554F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0" creationId="{FE434426-F5A5-8249-8C5F-8F46B329CD1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1" creationId="{2B18DD88-7C18-E94D-9772-A69D9A78BA97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2" creationId="{5B67FA09-4B92-A348-9751-0D9B58166A87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3" creationId="{15A2421F-3CE1-6442-8D74-C0F00A7BCA9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4" creationId="{236EFF94-6FF9-FD44-BA03-135283C21D41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5" creationId="{2C80DEA9-A087-D14E-A041-2647DB44993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6" creationId="{55ACFE85-9EE0-CC4A-847F-00AC21F16E60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7" creationId="{BEA6DD24-A8BB-544A-9751-A204273BCF6F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8" creationId="{18ED6190-51AF-F942-BABE-6A330BD7FAB0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49" creationId="{D8B08930-739D-1E47-B0B7-0D17A2A0FF0A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0" creationId="{EE268243-8AF4-5E4A-B046-1885A1F47F2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1" creationId="{2C730969-51A3-7149-8677-52544A3304E1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2" creationId="{F7D44CB5-2F7B-5A4E-ABD7-BA5DB9361FEB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3" creationId="{99E76684-74BD-674C-B50C-D374CE4F8B0B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4" creationId="{1E5BFE5D-08C7-0E46-ADE8-764BA427C43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5" creationId="{89B5B30F-5F76-F048-BD78-15D9A279F953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6" creationId="{B537BE2F-18A4-7A4B-9829-3F5CD15CC2A0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7" creationId="{DB161A0D-CFF3-B548-AE99-E3638E503B05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8" creationId="{19162147-B251-8543-8FF1-BD285B7CB61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59" creationId="{0565DCF4-F9D7-8947-A620-5EC19D694A70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0" creationId="{40ACDC38-96F6-1248-A755-6AB6B165FDDC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1" creationId="{E9627371-3047-9D4A-B70A-E6C780435FAB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2" creationId="{EB2F0DF1-0040-4A4B-93B5-49E632CFC1FB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3" creationId="{CDA332E9-47E3-0343-9479-41BC313F56FA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4" creationId="{1CE82F89-EBBE-E04C-A0F0-8EBCD75417F2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5" creationId="{8E9828C9-6E36-FF4C-88CF-F1C2C823358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6" creationId="{F14E29AB-94FE-E346-B986-445555ACA88A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7" creationId="{1C6F5E3D-72D6-9B43-A26F-FBDD009C9090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8" creationId="{D6F54485-BE22-954A-AB3D-1E3D5F6B07FD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69" creationId="{1DBFCB14-939B-3140-BECA-E8BB735FDE27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0" creationId="{A644BF4A-7EC7-B740-901E-2111C0345421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1" creationId="{0345A00B-13CC-2F43-9C8E-7FCA88C5DFBC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2" creationId="{2D30B496-9157-8A4D-9175-D0272833C251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3" creationId="{D85F3178-88D0-3643-BE27-5FDABC58152C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4" creationId="{CF3E8D10-6DD0-0448-BEA2-203887FFDEB8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5" creationId="{03F85601-8BCB-2F4B-89D1-B236F44EC378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6" creationId="{3AC7E3CA-5F7D-7949-B0E1-3BFFAF97706D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7" creationId="{A32E2152-0A2D-DE4E-ACCE-6D3DAD835169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8" creationId="{956C1F9C-50B1-D84E-AC35-F6AC44A37ED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79" creationId="{0C339FA3-555C-DF47-A893-E71A727A7298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80" creationId="{71C076FA-11CA-364C-A884-45D03C74D743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81" creationId="{FA096614-58AE-4744-B74D-3B7B473F2913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82" creationId="{A313726D-6188-5C49-BA03-843C07481E2D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299" creationId="{38AD0ECD-DA90-D341-B0D1-E821DA334FE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300" creationId="{266EB614-F7BE-CC45-9A23-EDF95BB37B8E}"/>
          </ac:spMkLst>
        </pc:spChg>
        <pc:spChg chg="mod topLvl">
          <ac:chgData name="Lois Hoyer" userId="8c378a1a5b622d94" providerId="LiveId" clId="{4D28AC46-269F-44FE-9C3B-AE79CE7537DE}" dt="2021-10-03T14:55:59.945" v="2602" actId="338"/>
          <ac:spMkLst>
            <pc:docMk/>
            <pc:sldMk cId="954159042" sldId="257"/>
            <ac:spMk id="301" creationId="{28E8E0BF-DBFB-3940-BC32-8675C4B71D6E}"/>
          </ac:spMkLst>
        </pc:spChg>
        <pc:spChg chg="mod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2" creationId="{5EBEC098-BEDE-C048-9483-573D0A1F313C}"/>
          </ac:spMkLst>
        </pc:spChg>
        <pc:spChg chg="mod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3" creationId="{627671DD-F726-0A4F-A320-3002DFF1AFA8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5" creationId="{B10C6112-FE53-6949-BC57-4E64F37DDB5D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6" creationId="{E5C7510B-3506-FA42-B74C-CC8F9F55524F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7" creationId="{5A049BA4-2887-0249-8DA8-5F3BC38C257E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8" creationId="{8BB82904-4718-FE49-9F8F-FE3EBB34C10A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09" creationId="{C2DF8A43-B881-4F4C-B6DA-FCA77B7E3371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0" creationId="{5FC280B9-F952-8842-903F-CDBA2604F3E8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1" creationId="{354D9C5F-C24C-1044-9776-23ABADDCD482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2" creationId="{D56356B0-6A30-4E4E-8704-C2DC6389BB70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3" creationId="{D7011E76-0597-8B43-9DD0-0B47142C96EA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4" creationId="{48017F2D-188A-0542-986D-4D080406614F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5" creationId="{433A6CAD-2286-0C45-88D2-FE54F1C3C205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6" creationId="{8E6EB4D5-40AB-1444-8006-54A1BBBD1C8B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7" creationId="{86AA4E07-573F-C44A-B65A-68B28D3465FE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8" creationId="{8FA4E89F-E150-EB4B-B263-C7846512B56F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19" creationId="{DAE8AB11-7A6D-7541-ADC6-B9BA1723EACE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0" creationId="{C4576AB0-52E5-CB49-BA0A-40CD2811F262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1" creationId="{D1409400-5957-C243-B5DB-E2928B1CE43F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2" creationId="{60057E65-B016-BA4A-A8E4-F4EDD0EC5591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3" creationId="{785E5300-5491-9F4E-BCB0-328CDC070842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4" creationId="{68C084C8-33D9-F242-A85C-F7FC857E1325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5" creationId="{A425EB8C-A8EA-FC41-9190-953902793C39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6" creationId="{4940AEB9-2CC3-544D-956A-43D8CE4E9948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7" creationId="{32719D5A-9799-644D-852B-53AE46CA37B5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8" creationId="{9C71777C-2EC4-9943-B08B-6E2FE4F9961B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29" creationId="{114A9C40-C360-7848-A030-AA1B75DFA3EF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30" creationId="{BBAFB8EB-14D4-1C47-9365-690BFDD50F0B}"/>
          </ac:spMkLst>
        </pc:spChg>
        <pc:spChg chg="mod topLvl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31" creationId="{876863B4-E4B6-024F-B155-9058C843EAB1}"/>
          </ac:spMkLst>
        </pc:spChg>
        <pc:spChg chg="mod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48" creationId="{1CD75AB0-1594-D74E-82A1-EE7A6941BF69}"/>
          </ac:spMkLst>
        </pc:spChg>
        <pc:spChg chg="mod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49" creationId="{65C8B04C-49FF-674A-93C4-71C76B8483ED}"/>
          </ac:spMkLst>
        </pc:spChg>
        <pc:spChg chg="mod">
          <ac:chgData name="Lois Hoyer" userId="8c378a1a5b622d94" providerId="LiveId" clId="{4D28AC46-269F-44FE-9C3B-AE79CE7537DE}" dt="2021-10-03T14:56:11.155" v="2603" actId="1582"/>
          <ac:spMkLst>
            <pc:docMk/>
            <pc:sldMk cId="954159042" sldId="257"/>
            <ac:spMk id="350" creationId="{031A17F7-7354-384E-8058-00495868DCBB}"/>
          </ac:spMkLst>
        </pc:spChg>
        <pc:spChg chg="mod topLvl">
          <ac:chgData name="Lois Hoyer" userId="8c378a1a5b622d94" providerId="LiveId" clId="{4D28AC46-269F-44FE-9C3B-AE79CE7537DE}" dt="2021-10-03T14:56:28.459" v="2605" actId="1582"/>
          <ac:spMkLst>
            <pc:docMk/>
            <pc:sldMk cId="954159042" sldId="257"/>
            <ac:spMk id="351" creationId="{6D9B4BFE-05E3-034B-88CB-71335E9B5235}"/>
          </ac:spMkLst>
        </pc:spChg>
        <pc:spChg chg="mod topLvl">
          <ac:chgData name="Lois Hoyer" userId="8c378a1a5b622d94" providerId="LiveId" clId="{4D28AC46-269F-44FE-9C3B-AE79CE7537DE}" dt="2021-10-03T14:56:28.459" v="2605" actId="1582"/>
          <ac:spMkLst>
            <pc:docMk/>
            <pc:sldMk cId="954159042" sldId="257"/>
            <ac:spMk id="353" creationId="{69A6DD2A-25E4-0440-ABF2-FC49340CA5BE}"/>
          </ac:spMkLst>
        </pc:spChg>
        <pc:spChg chg="mod topLvl">
          <ac:chgData name="Lois Hoyer" userId="8c378a1a5b622d94" providerId="LiveId" clId="{4D28AC46-269F-44FE-9C3B-AE79CE7537DE}" dt="2021-10-03T14:56:28.459" v="2605" actId="1582"/>
          <ac:spMkLst>
            <pc:docMk/>
            <pc:sldMk cId="954159042" sldId="257"/>
            <ac:spMk id="354" creationId="{611EF73E-40A3-184E-B41A-F5E1D2E8C16F}"/>
          </ac:spMkLst>
        </pc:spChg>
        <pc:spChg chg="mod topLvl">
          <ac:chgData name="Lois Hoyer" userId="8c378a1a5b622d94" providerId="LiveId" clId="{4D28AC46-269F-44FE-9C3B-AE79CE7537DE}" dt="2021-10-03T14:56:28.459" v="2605" actId="1582"/>
          <ac:spMkLst>
            <pc:docMk/>
            <pc:sldMk cId="954159042" sldId="257"/>
            <ac:spMk id="355" creationId="{BD38B845-BC09-CB4F-8454-C4B35FA26239}"/>
          </ac:spMkLst>
        </pc:spChg>
        <pc:spChg chg="mod topLvl">
          <ac:chgData name="Lois Hoyer" userId="8c378a1a5b622d94" providerId="LiveId" clId="{4D28AC46-269F-44FE-9C3B-AE79CE7537DE}" dt="2021-10-03T14:56:28.459" v="2605" actId="1582"/>
          <ac:spMkLst>
            <pc:docMk/>
            <pc:sldMk cId="954159042" sldId="257"/>
            <ac:spMk id="356" creationId="{D646CF31-C5F9-CE40-8F41-4F0C9A747AA9}"/>
          </ac:spMkLst>
        </pc:spChg>
        <pc:spChg chg="mod">
          <ac:chgData name="Lois Hoyer" userId="8c378a1a5b622d94" providerId="LiveId" clId="{4D28AC46-269F-44FE-9C3B-AE79CE7537DE}" dt="2021-10-03T14:55:14.128" v="2597" actId="165"/>
          <ac:spMkLst>
            <pc:docMk/>
            <pc:sldMk cId="954159042" sldId="257"/>
            <ac:spMk id="357" creationId="{3C506736-E249-F24C-B004-48C7FC547291}"/>
          </ac:spMkLst>
        </pc:spChg>
        <pc:spChg chg="mod">
          <ac:chgData name="Lois Hoyer" userId="8c378a1a5b622d94" providerId="LiveId" clId="{4D28AC46-269F-44FE-9C3B-AE79CE7537DE}" dt="2021-10-03T14:55:14.128" v="2597" actId="165"/>
          <ac:spMkLst>
            <pc:docMk/>
            <pc:sldMk cId="954159042" sldId="257"/>
            <ac:spMk id="358" creationId="{0CC6B486-A6BC-5E47-A566-008FFBBF44A1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367" creationId="{8DDBC149-17D4-8043-9BA1-5269F971EB96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368" creationId="{5DF8F4D0-EB5D-564F-ABFA-7118C9AEFB66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369" creationId="{842C41CA-CAA0-944F-BDFB-FC6FCEDA3BED}"/>
          </ac:spMkLst>
        </pc:spChg>
        <pc:spChg chg="mod topLvl">
          <ac:chgData name="Lois Hoyer" userId="8c378a1a5b622d94" providerId="LiveId" clId="{4D28AC46-269F-44FE-9C3B-AE79CE7537DE}" dt="2021-10-03T14:56:41.707" v="2606" actId="338"/>
          <ac:spMkLst>
            <pc:docMk/>
            <pc:sldMk cId="954159042" sldId="257"/>
            <ac:spMk id="370" creationId="{171A0D39-1074-6045-93DF-F7CD286B07A6}"/>
          </ac:spMkLst>
        </pc:spChg>
        <pc:grpChg chg="add del mod">
          <ac:chgData name="Lois Hoyer" userId="8c378a1a5b622d94" providerId="LiveId" clId="{4D28AC46-269F-44FE-9C3B-AE79CE7537DE}" dt="2021-09-15T20:25:24.293" v="1558" actId="165"/>
          <ac:grpSpMkLst>
            <pc:docMk/>
            <pc:sldMk cId="954159042" sldId="257"/>
            <ac:grpSpMk id="2" creationId="{93215A78-1D99-4AD4-88F3-CDF43286A90B}"/>
          </ac:grpSpMkLst>
        </pc:grpChg>
        <pc:grpChg chg="add mod">
          <ac:chgData name="Lois Hoyer" userId="8c378a1a5b622d94" providerId="LiveId" clId="{4D28AC46-269F-44FE-9C3B-AE79CE7537DE}" dt="2021-09-21T14:13:01.433" v="1700" actId="338"/>
          <ac:grpSpMkLst>
            <pc:docMk/>
            <pc:sldMk cId="954159042" sldId="257"/>
            <ac:grpSpMk id="2" creationId="{FC0059D2-3E77-426A-9FEA-EEEFE748D8E5}"/>
          </ac:grpSpMkLst>
        </pc:grpChg>
        <pc:grpChg chg="add mod">
          <ac:chgData name="Lois Hoyer" userId="8c378a1a5b622d94" providerId="LiveId" clId="{4D28AC46-269F-44FE-9C3B-AE79CE7537DE}" dt="2021-10-03T14:55:59.945" v="2602" actId="338"/>
          <ac:grpSpMkLst>
            <pc:docMk/>
            <pc:sldMk cId="954159042" sldId="257"/>
            <ac:grpSpMk id="3" creationId="{7A4F49BB-5D57-4E4C-BDEA-2B563C048C26}"/>
          </ac:grpSpMkLst>
        </pc:grpChg>
        <pc:grpChg chg="add del mod">
          <ac:chgData name="Lois Hoyer" userId="8c378a1a5b622d94" providerId="LiveId" clId="{4D28AC46-269F-44FE-9C3B-AE79CE7537DE}" dt="2021-09-21T14:10:56.027" v="1673" actId="165"/>
          <ac:grpSpMkLst>
            <pc:docMk/>
            <pc:sldMk cId="954159042" sldId="257"/>
            <ac:grpSpMk id="3" creationId="{F2557B46-08AD-43D4-852A-1B03AA4C5B9D}"/>
          </ac:grpSpMkLst>
        </pc:grpChg>
        <pc:grpChg chg="add del mod">
          <ac:chgData name="Lois Hoyer" userId="8c378a1a5b622d94" providerId="LiveId" clId="{4D28AC46-269F-44FE-9C3B-AE79CE7537DE}" dt="2021-10-03T14:55:14.128" v="2597" actId="165"/>
          <ac:grpSpMkLst>
            <pc:docMk/>
            <pc:sldMk cId="954159042" sldId="257"/>
            <ac:grpSpMk id="4" creationId="{51F50A6C-0712-4AA6-BA61-C57EB0CB909C}"/>
          </ac:grpSpMkLst>
        </pc:grpChg>
        <pc:grpChg chg="mod">
          <ac:chgData name="Lois Hoyer" userId="8c378a1a5b622d94" providerId="LiveId" clId="{4D28AC46-269F-44FE-9C3B-AE79CE7537DE}" dt="2021-10-03T14:56:41.707" v="2606" actId="338"/>
          <ac:grpSpMkLst>
            <pc:docMk/>
            <pc:sldMk cId="954159042" sldId="257"/>
            <ac:grpSpMk id="6" creationId="{105C592D-02B3-4DF7-AD6F-46E6D95BB339}"/>
          </ac:grpSpMkLst>
        </pc:grpChg>
        <pc:grpChg chg="add del mod">
          <ac:chgData name="Lois Hoyer" userId="8c378a1a5b622d94" providerId="LiveId" clId="{4D28AC46-269F-44FE-9C3B-AE79CE7537DE}" dt="2021-08-30T14:34:10.044" v="481" actId="165"/>
          <ac:grpSpMkLst>
            <pc:docMk/>
            <pc:sldMk cId="954159042" sldId="257"/>
            <ac:grpSpMk id="6" creationId="{A1726E96-309D-46E2-BE59-BF38311B7226}"/>
          </ac:grpSpMkLst>
        </pc:grpChg>
        <pc:grpChg chg="add mod">
          <ac:chgData name="Lois Hoyer" userId="8c378a1a5b622d94" providerId="LiveId" clId="{4D28AC46-269F-44FE-9C3B-AE79CE7537DE}" dt="2021-10-03T14:56:41.707" v="2606" actId="338"/>
          <ac:grpSpMkLst>
            <pc:docMk/>
            <pc:sldMk cId="954159042" sldId="257"/>
            <ac:grpSpMk id="7" creationId="{3D18C60D-BD48-4B32-9EF1-790D9C22F62B}"/>
          </ac:grpSpMkLst>
        </pc:grpChg>
        <pc:grpChg chg="add del mod topLvl">
          <ac:chgData name="Lois Hoyer" userId="8c378a1a5b622d94" providerId="LiveId" clId="{4D28AC46-269F-44FE-9C3B-AE79CE7537DE}" dt="2021-10-03T14:55:47.079" v="2600" actId="165"/>
          <ac:grpSpMkLst>
            <pc:docMk/>
            <pc:sldMk cId="954159042" sldId="257"/>
            <ac:grpSpMk id="8" creationId="{2D5F40AC-FC4E-4250-AF35-82EA870C55B4}"/>
          </ac:grpSpMkLst>
        </pc:grpChg>
        <pc:grpChg chg="add del mod topLvl">
          <ac:chgData name="Lois Hoyer" userId="8c378a1a5b622d94" providerId="LiveId" clId="{4D28AC46-269F-44FE-9C3B-AE79CE7537DE}" dt="2021-09-21T14:11:01.826" v="1674" actId="165"/>
          <ac:grpSpMkLst>
            <pc:docMk/>
            <pc:sldMk cId="954159042" sldId="257"/>
            <ac:grpSpMk id="9" creationId="{856A77B3-DBC9-4D41-AB60-E029FD6E9383}"/>
          </ac:grpSpMkLst>
        </pc:grpChg>
        <pc:grpChg chg="add mod topLvl">
          <ac:chgData name="Lois Hoyer" userId="8c378a1a5b622d94" providerId="LiveId" clId="{4D28AC46-269F-44FE-9C3B-AE79CE7537DE}" dt="2021-10-03T14:56:41.707" v="2606" actId="338"/>
          <ac:grpSpMkLst>
            <pc:docMk/>
            <pc:sldMk cId="954159042" sldId="257"/>
            <ac:grpSpMk id="10" creationId="{7B2D0E5F-1256-4D60-8799-53E8E4216219}"/>
          </ac:grpSpMkLst>
        </pc:grpChg>
        <pc:grpChg chg="add del mod">
          <ac:chgData name="Lois Hoyer" userId="8c378a1a5b622d94" providerId="LiveId" clId="{4D28AC46-269F-44FE-9C3B-AE79CE7537DE}" dt="2021-08-30T14:48:14.702" v="756" actId="165"/>
          <ac:grpSpMkLst>
            <pc:docMk/>
            <pc:sldMk cId="954159042" sldId="257"/>
            <ac:grpSpMk id="11" creationId="{EDCD9459-A801-4270-B45F-CE0313A8074E}"/>
          </ac:grpSpMkLst>
        </pc:grpChg>
        <pc:grpChg chg="add mod topLvl">
          <ac:chgData name="Lois Hoyer" userId="8c378a1a5b622d94" providerId="LiveId" clId="{4D28AC46-269F-44FE-9C3B-AE79CE7537DE}" dt="2021-10-03T14:56:41.707" v="2606" actId="338"/>
          <ac:grpSpMkLst>
            <pc:docMk/>
            <pc:sldMk cId="954159042" sldId="257"/>
            <ac:grpSpMk id="12" creationId="{C1DD9829-8985-46E3-89F5-4393B178712A}"/>
          </ac:grpSpMkLst>
        </pc:grpChg>
        <pc:grpChg chg="add del mod topLvl">
          <ac:chgData name="Lois Hoyer" userId="8c378a1a5b622d94" providerId="LiveId" clId="{4D28AC46-269F-44FE-9C3B-AE79CE7537DE}" dt="2021-10-03T14:55:20.624" v="2598" actId="165"/>
          <ac:grpSpMkLst>
            <pc:docMk/>
            <pc:sldMk cId="954159042" sldId="257"/>
            <ac:grpSpMk id="13" creationId="{0A2E8ADE-C0E2-41A2-8FCC-64857E530A23}"/>
          </ac:grpSpMkLst>
        </pc:grpChg>
        <pc:grpChg chg="add mod topLvl">
          <ac:chgData name="Lois Hoyer" userId="8c378a1a5b622d94" providerId="LiveId" clId="{4D28AC46-269F-44FE-9C3B-AE79CE7537DE}" dt="2021-10-03T14:56:41.707" v="2606" actId="338"/>
          <ac:grpSpMkLst>
            <pc:docMk/>
            <pc:sldMk cId="954159042" sldId="257"/>
            <ac:grpSpMk id="14" creationId="{86E6E1F4-323A-41AC-9BBD-F781B3C4D42A}"/>
          </ac:grpSpMkLst>
        </pc:grpChg>
        <pc:grpChg chg="add del mod">
          <ac:chgData name="Lois Hoyer" userId="8c378a1a5b622d94" providerId="LiveId" clId="{4D28AC46-269F-44FE-9C3B-AE79CE7537DE}" dt="2021-08-31T18:25:17.471" v="1435" actId="165"/>
          <ac:grpSpMkLst>
            <pc:docMk/>
            <pc:sldMk cId="954159042" sldId="257"/>
            <ac:grpSpMk id="20" creationId="{7D609A40-4F12-43D8-80E2-92EB1E6CA0C4}"/>
          </ac:grpSpMkLst>
        </pc:grpChg>
        <pc:grpChg chg="del mod">
          <ac:chgData name="Lois Hoyer" userId="8c378a1a5b622d94" providerId="LiveId" clId="{4D28AC46-269F-44FE-9C3B-AE79CE7537DE}" dt="2021-08-30T14:36:10.725" v="488" actId="165"/>
          <ac:grpSpMkLst>
            <pc:docMk/>
            <pc:sldMk cId="954159042" sldId="257"/>
            <ac:grpSpMk id="298" creationId="{08724BDB-A7E1-A741-8E84-3CBE50E1914D}"/>
          </ac:grpSpMkLst>
        </pc:grpChg>
        <pc:grpChg chg="del mod">
          <ac:chgData name="Lois Hoyer" userId="8c378a1a5b622d94" providerId="LiveId" clId="{4D28AC46-269F-44FE-9C3B-AE79CE7537DE}" dt="2021-08-30T14:41:25.327" v="562" actId="165"/>
          <ac:grpSpMkLst>
            <pc:docMk/>
            <pc:sldMk cId="954159042" sldId="257"/>
            <ac:grpSpMk id="362" creationId="{7A4D446B-B9ED-3549-8750-E28657289EDA}"/>
          </ac:grpSpMkLst>
        </pc:grpChg>
        <pc:graphicFrameChg chg="add del mod modGraphic">
          <ac:chgData name="Lois Hoyer" userId="8c378a1a5b622d94" providerId="LiveId" clId="{4D28AC46-269F-44FE-9C3B-AE79CE7537DE}" dt="2021-08-30T15:03:51.641" v="867" actId="478"/>
          <ac:graphicFrameMkLst>
            <pc:docMk/>
            <pc:sldMk cId="954159042" sldId="257"/>
            <ac:graphicFrameMk id="16" creationId="{E8AC6A56-2D4C-4164-BBEA-0A706208D305}"/>
          </ac:graphicFrameMkLst>
        </pc:graphicFrameChg>
        <pc:graphicFrameChg chg="add mod modGraphic">
          <ac:chgData name="Lois Hoyer" userId="8c378a1a5b622d94" providerId="LiveId" clId="{4D28AC46-269F-44FE-9C3B-AE79CE7537DE}" dt="2021-09-21T14:13:32.132" v="1713" actId="20577"/>
          <ac:graphicFrameMkLst>
            <pc:docMk/>
            <pc:sldMk cId="954159042" sldId="257"/>
            <ac:graphicFrameMk id="17" creationId="{7FEA7734-0AF1-480F-9C37-94C4B1BF7DAD}"/>
          </ac:graphicFrameMkLst>
        </pc:graphicFrameChg>
      </pc:sldChg>
      <pc:sldChg chg="addSp delSp modSp new mod">
        <pc:chgData name="Lois Hoyer" userId="8c378a1a5b622d94" providerId="LiveId" clId="{4D28AC46-269F-44FE-9C3B-AE79CE7537DE}" dt="2021-10-03T15:00:55.333" v="2622" actId="20577"/>
        <pc:sldMkLst>
          <pc:docMk/>
          <pc:sldMk cId="1877435059" sldId="258"/>
        </pc:sldMkLst>
        <pc:spChg chg="del">
          <ac:chgData name="Lois Hoyer" userId="8c378a1a5b622d94" providerId="LiveId" clId="{4D28AC46-269F-44FE-9C3B-AE79CE7537DE}" dt="2021-09-21T14:08:21.058" v="1650" actId="478"/>
          <ac:spMkLst>
            <pc:docMk/>
            <pc:sldMk cId="1877435059" sldId="258"/>
            <ac:spMk id="2" creationId="{E0294302-81CC-4F2E-A155-8A7D15C11DE9}"/>
          </ac:spMkLst>
        </pc:spChg>
        <pc:spChg chg="del">
          <ac:chgData name="Lois Hoyer" userId="8c378a1a5b622d94" providerId="LiveId" clId="{4D28AC46-269F-44FE-9C3B-AE79CE7537DE}" dt="2021-09-21T14:08:22.174" v="1651" actId="478"/>
          <ac:spMkLst>
            <pc:docMk/>
            <pc:sldMk cId="1877435059" sldId="258"/>
            <ac:spMk id="3" creationId="{F391504D-3795-4304-9867-B7819C19779F}"/>
          </ac:spMkLst>
        </pc:spChg>
        <pc:spChg chg="add del mod">
          <ac:chgData name="Lois Hoyer" userId="8c378a1a5b622d94" providerId="LiveId" clId="{4D28AC46-269F-44FE-9C3B-AE79CE7537DE}" dt="2021-09-21T14:18:55.441" v="2483" actId="478"/>
          <ac:spMkLst>
            <pc:docMk/>
            <pc:sldMk cId="1877435059" sldId="258"/>
            <ac:spMk id="4" creationId="{1447961E-C09D-4F5D-A2AC-A535246409B0}"/>
          </ac:spMkLst>
        </pc:spChg>
        <pc:spChg chg="add mod">
          <ac:chgData name="Lois Hoyer" userId="8c378a1a5b622d94" providerId="LiveId" clId="{4D28AC46-269F-44FE-9C3B-AE79CE7537DE}" dt="2021-10-03T15:00:55.333" v="2622" actId="20577"/>
          <ac:spMkLst>
            <pc:docMk/>
            <pc:sldMk cId="1877435059" sldId="258"/>
            <ac:spMk id="5" creationId="{5ED09CD6-DC73-47F5-8024-2A4159B4A840}"/>
          </ac:spMkLst>
        </pc:spChg>
      </pc:sldChg>
      <pc:sldMasterChg chg="modSp modSldLayout">
        <pc:chgData name="Lois Hoyer" userId="8c378a1a5b622d94" providerId="LiveId" clId="{4D28AC46-269F-44FE-9C3B-AE79CE7537DE}" dt="2021-08-30T14:10:51.267" v="0"/>
        <pc:sldMasterMkLst>
          <pc:docMk/>
          <pc:sldMasterMk cId="3070493599" sldId="2147483660"/>
        </pc:sldMasterMkLst>
        <pc:spChg chg="mod">
          <ac:chgData name="Lois Hoyer" userId="8c378a1a5b622d94" providerId="LiveId" clId="{4D28AC46-269F-44FE-9C3B-AE79CE7537DE}" dt="2021-08-30T14:10:51.267" v="0"/>
          <ac:spMkLst>
            <pc:docMk/>
            <pc:sldMasterMk cId="3070493599" sldId="2147483660"/>
            <ac:spMk id="2" creationId="{00000000-0000-0000-0000-000000000000}"/>
          </ac:spMkLst>
        </pc:spChg>
        <pc:spChg chg="mod">
          <ac:chgData name="Lois Hoyer" userId="8c378a1a5b622d94" providerId="LiveId" clId="{4D28AC46-269F-44FE-9C3B-AE79CE7537DE}" dt="2021-08-30T14:10:51.267" v="0"/>
          <ac:spMkLst>
            <pc:docMk/>
            <pc:sldMasterMk cId="3070493599" sldId="2147483660"/>
            <ac:spMk id="3" creationId="{00000000-0000-0000-0000-000000000000}"/>
          </ac:spMkLst>
        </pc:spChg>
        <pc:spChg chg="mod">
          <ac:chgData name="Lois Hoyer" userId="8c378a1a5b622d94" providerId="LiveId" clId="{4D28AC46-269F-44FE-9C3B-AE79CE7537DE}" dt="2021-08-30T14:10:51.267" v="0"/>
          <ac:spMkLst>
            <pc:docMk/>
            <pc:sldMasterMk cId="3070493599" sldId="2147483660"/>
            <ac:spMk id="4" creationId="{00000000-0000-0000-0000-000000000000}"/>
          </ac:spMkLst>
        </pc:spChg>
        <pc:spChg chg="mod">
          <ac:chgData name="Lois Hoyer" userId="8c378a1a5b622d94" providerId="LiveId" clId="{4D28AC46-269F-44FE-9C3B-AE79CE7537DE}" dt="2021-08-30T14:10:51.267" v="0"/>
          <ac:spMkLst>
            <pc:docMk/>
            <pc:sldMasterMk cId="3070493599" sldId="2147483660"/>
            <ac:spMk id="5" creationId="{00000000-0000-0000-0000-000000000000}"/>
          </ac:spMkLst>
        </pc:spChg>
        <pc:spChg chg="mod">
          <ac:chgData name="Lois Hoyer" userId="8c378a1a5b622d94" providerId="LiveId" clId="{4D28AC46-269F-44FE-9C3B-AE79CE7537DE}" dt="2021-08-30T14:10:51.267" v="0"/>
          <ac:spMkLst>
            <pc:docMk/>
            <pc:sldMasterMk cId="3070493599" sldId="2147483660"/>
            <ac:spMk id="6" creationId="{00000000-0000-0000-0000-000000000000}"/>
          </ac:spMkLst>
        </pc:sp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3463929669" sldId="2147483661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3463929669" sldId="2147483661"/>
              <ac:spMk id="2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3463929669" sldId="2147483661"/>
              <ac:spMk id="3" creationId="{00000000-0000-0000-0000-000000000000}"/>
            </ac:spMkLst>
          </pc:spChg>
        </pc:sldLayout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1002162929" sldId="2147483663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1002162929" sldId="2147483663"/>
              <ac:spMk id="2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1002162929" sldId="2147483663"/>
              <ac:spMk id="3" creationId="{00000000-0000-0000-0000-000000000000}"/>
            </ac:spMkLst>
          </pc:spChg>
        </pc:sldLayout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2241393901" sldId="2147483664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241393901" sldId="2147483664"/>
              <ac:spMk id="3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241393901" sldId="2147483664"/>
              <ac:spMk id="4" creationId="{00000000-0000-0000-0000-000000000000}"/>
            </ac:spMkLst>
          </pc:spChg>
        </pc:sldLayout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2777587075" sldId="2147483665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777587075" sldId="2147483665"/>
              <ac:spMk id="2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777587075" sldId="2147483665"/>
              <ac:spMk id="3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777587075" sldId="2147483665"/>
              <ac:spMk id="4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777587075" sldId="2147483665"/>
              <ac:spMk id="5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2777587075" sldId="2147483665"/>
              <ac:spMk id="6" creationId="{00000000-0000-0000-0000-000000000000}"/>
            </ac:spMkLst>
          </pc:spChg>
        </pc:sldLayout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4151445018" sldId="2147483668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4151445018" sldId="2147483668"/>
              <ac:spMk id="2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4151445018" sldId="2147483668"/>
              <ac:spMk id="3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4151445018" sldId="2147483668"/>
              <ac:spMk id="4" creationId="{00000000-0000-0000-0000-000000000000}"/>
            </ac:spMkLst>
          </pc:spChg>
        </pc:sldLayout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477290863" sldId="2147483669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477290863" sldId="2147483669"/>
              <ac:spMk id="2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477290863" sldId="2147483669"/>
              <ac:spMk id="3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477290863" sldId="2147483669"/>
              <ac:spMk id="4" creationId="{00000000-0000-0000-0000-000000000000}"/>
            </ac:spMkLst>
          </pc:spChg>
        </pc:sldLayoutChg>
        <pc:sldLayoutChg chg="modSp">
          <pc:chgData name="Lois Hoyer" userId="8c378a1a5b622d94" providerId="LiveId" clId="{4D28AC46-269F-44FE-9C3B-AE79CE7537DE}" dt="2021-08-30T14:10:51.267" v="0"/>
          <pc:sldLayoutMkLst>
            <pc:docMk/>
            <pc:sldMasterMk cId="3070493599" sldId="2147483660"/>
            <pc:sldLayoutMk cId="1062098527" sldId="2147483671"/>
          </pc:sldLayoutMkLst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1062098527" sldId="2147483671"/>
              <ac:spMk id="2" creationId="{00000000-0000-0000-0000-000000000000}"/>
            </ac:spMkLst>
          </pc:spChg>
          <pc:spChg chg="mod">
            <ac:chgData name="Lois Hoyer" userId="8c378a1a5b622d94" providerId="LiveId" clId="{4D28AC46-269F-44FE-9C3B-AE79CE7537DE}" dt="2021-08-30T14:10:51.267" v="0"/>
            <ac:spMkLst>
              <pc:docMk/>
              <pc:sldMasterMk cId="3070493599" sldId="2147483660"/>
              <pc:sldLayoutMk cId="1062098527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649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906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14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53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965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63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046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680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26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791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007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20A65-16B9-FA42-B754-C65D9F588E00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339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C0059D2-3E77-426A-9FEA-EEEFE748D8E5}"/>
              </a:ext>
            </a:extLst>
          </p:cNvPr>
          <p:cNvGrpSpPr/>
          <p:nvPr/>
        </p:nvGrpSpPr>
        <p:grpSpPr>
          <a:xfrm>
            <a:off x="451529" y="1266700"/>
            <a:ext cx="8386642" cy="228600"/>
            <a:chOff x="451529" y="1266700"/>
            <a:chExt cx="8386642" cy="228600"/>
          </a:xfrm>
        </p:grpSpPr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E47BDEE6-1FED-354C-866D-1150E855C0DE}"/>
                </a:ext>
              </a:extLst>
            </p:cNvPr>
            <p:cNvSpPr/>
            <p:nvPr/>
          </p:nvSpPr>
          <p:spPr>
            <a:xfrm>
              <a:off x="451529" y="1266700"/>
              <a:ext cx="42672" cy="228600"/>
            </a:xfrm>
            <a:prstGeom prst="rect">
              <a:avLst/>
            </a:prstGeom>
            <a:solidFill>
              <a:srgbClr val="FF7E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14088EE7-0D0C-B346-86D2-8863D17A2FAD}"/>
                </a:ext>
              </a:extLst>
            </p:cNvPr>
            <p:cNvSpPr/>
            <p:nvPr/>
          </p:nvSpPr>
          <p:spPr>
            <a:xfrm>
              <a:off x="494201" y="1266700"/>
              <a:ext cx="835152" cy="228600"/>
            </a:xfrm>
            <a:prstGeom prst="rect">
              <a:avLst/>
            </a:prstGeom>
            <a:solidFill>
              <a:srgbClr val="FF26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2" name="Rectangle 151">
              <a:extLst>
                <a:ext uri="{FF2B5EF4-FFF2-40B4-BE49-F238E27FC236}">
                  <a16:creationId xmlns:a16="http://schemas.microsoft.com/office/drawing/2014/main" id="{F3D8D4FD-5680-3B40-9747-BEC282B9D564}"/>
                </a:ext>
              </a:extLst>
            </p:cNvPr>
            <p:cNvSpPr/>
            <p:nvPr/>
          </p:nvSpPr>
          <p:spPr>
            <a:xfrm>
              <a:off x="132935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3" name="Rectangle 152">
              <a:extLst>
                <a:ext uri="{FF2B5EF4-FFF2-40B4-BE49-F238E27FC236}">
                  <a16:creationId xmlns:a16="http://schemas.microsoft.com/office/drawing/2014/main" id="{E6101CAE-BB8D-EC4E-A376-6DF9167C6660}"/>
                </a:ext>
              </a:extLst>
            </p:cNvPr>
            <p:cNvSpPr/>
            <p:nvPr/>
          </p:nvSpPr>
          <p:spPr>
            <a:xfrm>
              <a:off x="142460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6C9A7B49-8001-2448-B367-E979648C0E52}"/>
                </a:ext>
              </a:extLst>
            </p:cNvPr>
            <p:cNvSpPr/>
            <p:nvPr/>
          </p:nvSpPr>
          <p:spPr>
            <a:xfrm>
              <a:off x="151985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FF60F57A-41F4-0A46-9196-4712729E387C}"/>
                </a:ext>
              </a:extLst>
            </p:cNvPr>
            <p:cNvSpPr/>
            <p:nvPr/>
          </p:nvSpPr>
          <p:spPr>
            <a:xfrm>
              <a:off x="161510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4567C693-5042-464F-9A67-317B5C3A0A8D}"/>
                </a:ext>
              </a:extLst>
            </p:cNvPr>
            <p:cNvSpPr/>
            <p:nvPr/>
          </p:nvSpPr>
          <p:spPr>
            <a:xfrm>
              <a:off x="171035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1ACF17DA-E09B-E641-B111-30EE388C3FC2}"/>
                </a:ext>
              </a:extLst>
            </p:cNvPr>
            <p:cNvSpPr/>
            <p:nvPr/>
          </p:nvSpPr>
          <p:spPr>
            <a:xfrm>
              <a:off x="180560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E15071A5-0F03-6A46-9E8B-00829A46CDBB}"/>
                </a:ext>
              </a:extLst>
            </p:cNvPr>
            <p:cNvSpPr/>
            <p:nvPr/>
          </p:nvSpPr>
          <p:spPr>
            <a:xfrm>
              <a:off x="190085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6BA96F28-2A22-6D42-9CEE-A6DB0C38B0C9}"/>
                </a:ext>
              </a:extLst>
            </p:cNvPr>
            <p:cNvSpPr/>
            <p:nvPr/>
          </p:nvSpPr>
          <p:spPr>
            <a:xfrm>
              <a:off x="199610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C3E76E26-5C7D-8848-BB46-5B2E530DCD5C}"/>
                </a:ext>
              </a:extLst>
            </p:cNvPr>
            <p:cNvSpPr/>
            <p:nvPr/>
          </p:nvSpPr>
          <p:spPr>
            <a:xfrm>
              <a:off x="208247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F8424D00-05B6-CE4F-BCCE-16CDED4530AE}"/>
                </a:ext>
              </a:extLst>
            </p:cNvPr>
            <p:cNvSpPr/>
            <p:nvPr/>
          </p:nvSpPr>
          <p:spPr>
            <a:xfrm>
              <a:off x="217772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87365F4B-0ABB-6343-B0D6-265F7334B295}"/>
                </a:ext>
              </a:extLst>
            </p:cNvPr>
            <p:cNvSpPr/>
            <p:nvPr/>
          </p:nvSpPr>
          <p:spPr>
            <a:xfrm>
              <a:off x="227297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91FB8AE8-D5D2-B64A-9C0A-0E8093679156}"/>
                </a:ext>
              </a:extLst>
            </p:cNvPr>
            <p:cNvSpPr/>
            <p:nvPr/>
          </p:nvSpPr>
          <p:spPr>
            <a:xfrm>
              <a:off x="237710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E8F7B4BB-5EEB-0B4A-8588-DCC29A320CB8}"/>
                </a:ext>
              </a:extLst>
            </p:cNvPr>
            <p:cNvSpPr/>
            <p:nvPr/>
          </p:nvSpPr>
          <p:spPr>
            <a:xfrm>
              <a:off x="247235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051839E9-0386-AB42-A6DF-A5A17026A531}"/>
                </a:ext>
              </a:extLst>
            </p:cNvPr>
            <p:cNvSpPr/>
            <p:nvPr/>
          </p:nvSpPr>
          <p:spPr>
            <a:xfrm>
              <a:off x="256760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026A5C82-0419-5140-AAA6-563DADFED43E}"/>
                </a:ext>
              </a:extLst>
            </p:cNvPr>
            <p:cNvSpPr/>
            <p:nvPr/>
          </p:nvSpPr>
          <p:spPr>
            <a:xfrm>
              <a:off x="2662853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C6435C8B-93BE-384F-A1A6-03657E6953DB}"/>
                </a:ext>
              </a:extLst>
            </p:cNvPr>
            <p:cNvSpPr/>
            <p:nvPr/>
          </p:nvSpPr>
          <p:spPr>
            <a:xfrm>
              <a:off x="2758099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EF2D7DF4-DFCB-7443-990E-C5D741AB09AA}"/>
                </a:ext>
              </a:extLst>
            </p:cNvPr>
            <p:cNvSpPr/>
            <p:nvPr/>
          </p:nvSpPr>
          <p:spPr>
            <a:xfrm>
              <a:off x="28488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181A803C-FAEE-CF40-B340-31C4EE31B1B5}"/>
                </a:ext>
              </a:extLst>
            </p:cNvPr>
            <p:cNvSpPr/>
            <p:nvPr/>
          </p:nvSpPr>
          <p:spPr>
            <a:xfrm>
              <a:off x="29440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C9EF19B0-B46A-5C47-9035-E6B9A0C2B353}"/>
                </a:ext>
              </a:extLst>
            </p:cNvPr>
            <p:cNvSpPr/>
            <p:nvPr/>
          </p:nvSpPr>
          <p:spPr>
            <a:xfrm>
              <a:off x="30393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81A37607-0604-354D-9EE2-84C9FC55B924}"/>
                </a:ext>
              </a:extLst>
            </p:cNvPr>
            <p:cNvSpPr/>
            <p:nvPr/>
          </p:nvSpPr>
          <p:spPr>
            <a:xfrm>
              <a:off x="31345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A80B244B-D767-374D-9E0D-BD4F4B2B6A85}"/>
                </a:ext>
              </a:extLst>
            </p:cNvPr>
            <p:cNvSpPr/>
            <p:nvPr/>
          </p:nvSpPr>
          <p:spPr>
            <a:xfrm>
              <a:off x="32298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921C9BD1-E966-BB4F-897B-2E23C26268EF}"/>
                </a:ext>
              </a:extLst>
            </p:cNvPr>
            <p:cNvSpPr/>
            <p:nvPr/>
          </p:nvSpPr>
          <p:spPr>
            <a:xfrm>
              <a:off x="33250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B7A2C6DD-64F5-924B-8A11-559C1FF54F24}"/>
                </a:ext>
              </a:extLst>
            </p:cNvPr>
            <p:cNvSpPr/>
            <p:nvPr/>
          </p:nvSpPr>
          <p:spPr>
            <a:xfrm>
              <a:off x="34203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CC637010-7190-5D43-9861-9FE9C0B9C637}"/>
                </a:ext>
              </a:extLst>
            </p:cNvPr>
            <p:cNvSpPr/>
            <p:nvPr/>
          </p:nvSpPr>
          <p:spPr>
            <a:xfrm>
              <a:off x="35155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0F9A79E5-E715-DF46-94B4-283C75FDF5B5}"/>
                </a:ext>
              </a:extLst>
            </p:cNvPr>
            <p:cNvSpPr/>
            <p:nvPr/>
          </p:nvSpPr>
          <p:spPr>
            <a:xfrm>
              <a:off x="36108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0F308568-0608-434B-A937-766A4389557E}"/>
                </a:ext>
              </a:extLst>
            </p:cNvPr>
            <p:cNvSpPr/>
            <p:nvPr/>
          </p:nvSpPr>
          <p:spPr>
            <a:xfrm>
              <a:off x="37060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2CCEB257-787F-EA48-8E2C-4B517D5DA5BF}"/>
                </a:ext>
              </a:extLst>
            </p:cNvPr>
            <p:cNvSpPr/>
            <p:nvPr/>
          </p:nvSpPr>
          <p:spPr>
            <a:xfrm>
              <a:off x="38013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F9F8D19F-6611-A149-9FDB-2AD22ED6FC74}"/>
                </a:ext>
              </a:extLst>
            </p:cNvPr>
            <p:cNvSpPr/>
            <p:nvPr/>
          </p:nvSpPr>
          <p:spPr>
            <a:xfrm>
              <a:off x="38965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D5554AB5-89C4-334C-8587-63F2EE2EC787}"/>
                </a:ext>
              </a:extLst>
            </p:cNvPr>
            <p:cNvSpPr/>
            <p:nvPr/>
          </p:nvSpPr>
          <p:spPr>
            <a:xfrm>
              <a:off x="39918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76CB726D-0FF5-E142-8216-B7E957BBEA4F}"/>
                </a:ext>
              </a:extLst>
            </p:cNvPr>
            <p:cNvSpPr/>
            <p:nvPr/>
          </p:nvSpPr>
          <p:spPr>
            <a:xfrm>
              <a:off x="408705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816ED7B1-27E2-BD4B-AE4C-62439F9B285D}"/>
                </a:ext>
              </a:extLst>
            </p:cNvPr>
            <p:cNvSpPr/>
            <p:nvPr/>
          </p:nvSpPr>
          <p:spPr>
            <a:xfrm>
              <a:off x="418230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C0EB5888-6015-A347-8626-C0078961E8A6}"/>
                </a:ext>
              </a:extLst>
            </p:cNvPr>
            <p:cNvSpPr/>
            <p:nvPr/>
          </p:nvSpPr>
          <p:spPr>
            <a:xfrm>
              <a:off x="4277551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7BD4F00C-2B22-E64A-96F9-BA6A73143268}"/>
                </a:ext>
              </a:extLst>
            </p:cNvPr>
            <p:cNvSpPr/>
            <p:nvPr/>
          </p:nvSpPr>
          <p:spPr>
            <a:xfrm>
              <a:off x="437737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6DEF87D1-6CF1-9340-B95B-B51158692994}"/>
                </a:ext>
              </a:extLst>
            </p:cNvPr>
            <p:cNvSpPr/>
            <p:nvPr/>
          </p:nvSpPr>
          <p:spPr>
            <a:xfrm>
              <a:off x="447262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ED460973-2EC4-164C-9230-2E2FC437F608}"/>
                </a:ext>
              </a:extLst>
            </p:cNvPr>
            <p:cNvSpPr/>
            <p:nvPr/>
          </p:nvSpPr>
          <p:spPr>
            <a:xfrm>
              <a:off x="456787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A67A168B-CD07-3A4D-9EC6-39232454EF33}"/>
                </a:ext>
              </a:extLst>
            </p:cNvPr>
            <p:cNvSpPr/>
            <p:nvPr/>
          </p:nvSpPr>
          <p:spPr>
            <a:xfrm>
              <a:off x="466312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1FA06149-52A1-0E4A-AD9E-246403FB91D3}"/>
                </a:ext>
              </a:extLst>
            </p:cNvPr>
            <p:cNvSpPr/>
            <p:nvPr/>
          </p:nvSpPr>
          <p:spPr>
            <a:xfrm>
              <a:off x="475837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9" name="Rectangle 188">
              <a:extLst>
                <a:ext uri="{FF2B5EF4-FFF2-40B4-BE49-F238E27FC236}">
                  <a16:creationId xmlns:a16="http://schemas.microsoft.com/office/drawing/2014/main" id="{D7E45AE7-BE73-6D4C-9C3F-FE825C89CEE0}"/>
                </a:ext>
              </a:extLst>
            </p:cNvPr>
            <p:cNvSpPr/>
            <p:nvPr/>
          </p:nvSpPr>
          <p:spPr>
            <a:xfrm>
              <a:off x="485362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A4ACA94D-5710-774D-9FFE-98E5980BA3E5}"/>
                </a:ext>
              </a:extLst>
            </p:cNvPr>
            <p:cNvSpPr/>
            <p:nvPr/>
          </p:nvSpPr>
          <p:spPr>
            <a:xfrm>
              <a:off x="494887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1" name="Rectangle 190">
              <a:extLst>
                <a:ext uri="{FF2B5EF4-FFF2-40B4-BE49-F238E27FC236}">
                  <a16:creationId xmlns:a16="http://schemas.microsoft.com/office/drawing/2014/main" id="{434EB71F-528C-2740-9745-8C677E8645E7}"/>
                </a:ext>
              </a:extLst>
            </p:cNvPr>
            <p:cNvSpPr/>
            <p:nvPr/>
          </p:nvSpPr>
          <p:spPr>
            <a:xfrm>
              <a:off x="504412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2" name="Rectangle 191">
              <a:extLst>
                <a:ext uri="{FF2B5EF4-FFF2-40B4-BE49-F238E27FC236}">
                  <a16:creationId xmlns:a16="http://schemas.microsoft.com/office/drawing/2014/main" id="{8D7E5192-FDA1-8E49-874E-98D12860A49E}"/>
                </a:ext>
              </a:extLst>
            </p:cNvPr>
            <p:cNvSpPr/>
            <p:nvPr/>
          </p:nvSpPr>
          <p:spPr>
            <a:xfrm>
              <a:off x="513937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D1756C9C-093B-6F4B-A1C8-A36277A52F7B}"/>
                </a:ext>
              </a:extLst>
            </p:cNvPr>
            <p:cNvSpPr/>
            <p:nvPr/>
          </p:nvSpPr>
          <p:spPr>
            <a:xfrm>
              <a:off x="523462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CF8333CD-E823-9F46-952D-4A9544C8CCB2}"/>
                </a:ext>
              </a:extLst>
            </p:cNvPr>
            <p:cNvSpPr/>
            <p:nvPr/>
          </p:nvSpPr>
          <p:spPr>
            <a:xfrm>
              <a:off x="532987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09B71641-662A-1149-900E-6D86F57EE8F1}"/>
                </a:ext>
              </a:extLst>
            </p:cNvPr>
            <p:cNvSpPr/>
            <p:nvPr/>
          </p:nvSpPr>
          <p:spPr>
            <a:xfrm>
              <a:off x="5425122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0C25A076-CEA7-C947-B00D-7E3AF005DA7F}"/>
                </a:ext>
              </a:extLst>
            </p:cNvPr>
            <p:cNvSpPr/>
            <p:nvPr/>
          </p:nvSpPr>
          <p:spPr>
            <a:xfrm>
              <a:off x="5529250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7" name="Rectangle 196">
              <a:extLst>
                <a:ext uri="{FF2B5EF4-FFF2-40B4-BE49-F238E27FC236}">
                  <a16:creationId xmlns:a16="http://schemas.microsoft.com/office/drawing/2014/main" id="{E2A48959-0F9F-9546-A9E3-A856EE9B562D}"/>
                </a:ext>
              </a:extLst>
            </p:cNvPr>
            <p:cNvSpPr/>
            <p:nvPr/>
          </p:nvSpPr>
          <p:spPr>
            <a:xfrm>
              <a:off x="5624500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8" name="Rectangle 197">
              <a:extLst>
                <a:ext uri="{FF2B5EF4-FFF2-40B4-BE49-F238E27FC236}">
                  <a16:creationId xmlns:a16="http://schemas.microsoft.com/office/drawing/2014/main" id="{849546D3-6DBC-F844-9BFB-1C23115AC68A}"/>
                </a:ext>
              </a:extLst>
            </p:cNvPr>
            <p:cNvSpPr/>
            <p:nvPr/>
          </p:nvSpPr>
          <p:spPr>
            <a:xfrm>
              <a:off x="5728628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9" name="Rectangle 198">
              <a:extLst>
                <a:ext uri="{FF2B5EF4-FFF2-40B4-BE49-F238E27FC236}">
                  <a16:creationId xmlns:a16="http://schemas.microsoft.com/office/drawing/2014/main" id="{38157566-17A3-7549-AC6B-3677850FE057}"/>
                </a:ext>
              </a:extLst>
            </p:cNvPr>
            <p:cNvSpPr/>
            <p:nvPr/>
          </p:nvSpPr>
          <p:spPr>
            <a:xfrm>
              <a:off x="582387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0" name="Rectangle 199">
              <a:extLst>
                <a:ext uri="{FF2B5EF4-FFF2-40B4-BE49-F238E27FC236}">
                  <a16:creationId xmlns:a16="http://schemas.microsoft.com/office/drawing/2014/main" id="{BAC4B426-8CB9-F94F-8ED7-CFBA3617F72C}"/>
                </a:ext>
              </a:extLst>
            </p:cNvPr>
            <p:cNvSpPr/>
            <p:nvPr/>
          </p:nvSpPr>
          <p:spPr>
            <a:xfrm>
              <a:off x="591383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1" name="Rectangle 200">
              <a:extLst>
                <a:ext uri="{FF2B5EF4-FFF2-40B4-BE49-F238E27FC236}">
                  <a16:creationId xmlns:a16="http://schemas.microsoft.com/office/drawing/2014/main" id="{88F1D954-12FF-0845-987E-A6C951E22953}"/>
                </a:ext>
              </a:extLst>
            </p:cNvPr>
            <p:cNvSpPr/>
            <p:nvPr/>
          </p:nvSpPr>
          <p:spPr>
            <a:xfrm>
              <a:off x="6009085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2" name="Rectangle 201">
              <a:extLst>
                <a:ext uri="{FF2B5EF4-FFF2-40B4-BE49-F238E27FC236}">
                  <a16:creationId xmlns:a16="http://schemas.microsoft.com/office/drawing/2014/main" id="{BDA7CF03-9241-A840-A6DD-A25FD08E4A2E}"/>
                </a:ext>
              </a:extLst>
            </p:cNvPr>
            <p:cNvSpPr/>
            <p:nvPr/>
          </p:nvSpPr>
          <p:spPr>
            <a:xfrm>
              <a:off x="6095457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3" name="Rectangle 202">
              <a:extLst>
                <a:ext uri="{FF2B5EF4-FFF2-40B4-BE49-F238E27FC236}">
                  <a16:creationId xmlns:a16="http://schemas.microsoft.com/office/drawing/2014/main" id="{75AE0D25-17EB-FB4F-93AA-77C6F7EC4325}"/>
                </a:ext>
              </a:extLst>
            </p:cNvPr>
            <p:cNvSpPr/>
            <p:nvPr/>
          </p:nvSpPr>
          <p:spPr>
            <a:xfrm>
              <a:off x="6190707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4" name="Rectangle 203">
              <a:extLst>
                <a:ext uri="{FF2B5EF4-FFF2-40B4-BE49-F238E27FC236}">
                  <a16:creationId xmlns:a16="http://schemas.microsoft.com/office/drawing/2014/main" id="{FEA841B3-43D7-FC42-9278-7D2E854AFC14}"/>
                </a:ext>
              </a:extLst>
            </p:cNvPr>
            <p:cNvSpPr/>
            <p:nvPr/>
          </p:nvSpPr>
          <p:spPr>
            <a:xfrm>
              <a:off x="6285957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5" name="Rectangle 204">
              <a:extLst>
                <a:ext uri="{FF2B5EF4-FFF2-40B4-BE49-F238E27FC236}">
                  <a16:creationId xmlns:a16="http://schemas.microsoft.com/office/drawing/2014/main" id="{13B0B2E0-EA5C-0946-9D17-9798535E8A40}"/>
                </a:ext>
              </a:extLst>
            </p:cNvPr>
            <p:cNvSpPr/>
            <p:nvPr/>
          </p:nvSpPr>
          <p:spPr>
            <a:xfrm>
              <a:off x="6381207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6" name="Rectangle 205">
              <a:extLst>
                <a:ext uri="{FF2B5EF4-FFF2-40B4-BE49-F238E27FC236}">
                  <a16:creationId xmlns:a16="http://schemas.microsoft.com/office/drawing/2014/main" id="{2DABDFAF-4A4E-F648-A187-42BE32B71F51}"/>
                </a:ext>
              </a:extLst>
            </p:cNvPr>
            <p:cNvSpPr/>
            <p:nvPr/>
          </p:nvSpPr>
          <p:spPr>
            <a:xfrm>
              <a:off x="6467579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7" name="Rectangle 206">
              <a:extLst>
                <a:ext uri="{FF2B5EF4-FFF2-40B4-BE49-F238E27FC236}">
                  <a16:creationId xmlns:a16="http://schemas.microsoft.com/office/drawing/2014/main" id="{3C1E6975-E941-6443-872A-6B87291F9BDB}"/>
                </a:ext>
              </a:extLst>
            </p:cNvPr>
            <p:cNvSpPr/>
            <p:nvPr/>
          </p:nvSpPr>
          <p:spPr>
            <a:xfrm>
              <a:off x="6562829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8" name="Rectangle 207">
              <a:extLst>
                <a:ext uri="{FF2B5EF4-FFF2-40B4-BE49-F238E27FC236}">
                  <a16:creationId xmlns:a16="http://schemas.microsoft.com/office/drawing/2014/main" id="{8B3E10D9-3AA1-A84D-AF8C-8AED47BCB266}"/>
                </a:ext>
              </a:extLst>
            </p:cNvPr>
            <p:cNvSpPr/>
            <p:nvPr/>
          </p:nvSpPr>
          <p:spPr>
            <a:xfrm>
              <a:off x="6658079" y="1266700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09" name="Rectangle 208">
              <a:extLst>
                <a:ext uri="{FF2B5EF4-FFF2-40B4-BE49-F238E27FC236}">
                  <a16:creationId xmlns:a16="http://schemas.microsoft.com/office/drawing/2014/main" id="{51016769-AF00-9149-ABB2-AB801F073387}"/>
                </a:ext>
              </a:extLst>
            </p:cNvPr>
            <p:cNvSpPr/>
            <p:nvPr/>
          </p:nvSpPr>
          <p:spPr>
            <a:xfrm>
              <a:off x="6754653" y="1266700"/>
              <a:ext cx="1499616" cy="228600"/>
            </a:xfrm>
            <a:prstGeom prst="rect">
              <a:avLst/>
            </a:prstGeom>
            <a:solidFill>
              <a:srgbClr val="73FB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10" name="Rectangle 209">
              <a:extLst>
                <a:ext uri="{FF2B5EF4-FFF2-40B4-BE49-F238E27FC236}">
                  <a16:creationId xmlns:a16="http://schemas.microsoft.com/office/drawing/2014/main" id="{CB809839-FBA7-A34A-889F-6C81E2B50E62}"/>
                </a:ext>
              </a:extLst>
            </p:cNvPr>
            <p:cNvSpPr/>
            <p:nvPr/>
          </p:nvSpPr>
          <p:spPr>
            <a:xfrm>
              <a:off x="8256644" y="1266700"/>
              <a:ext cx="518160" cy="228600"/>
            </a:xfrm>
            <a:prstGeom prst="rect">
              <a:avLst/>
            </a:prstGeom>
            <a:solidFill>
              <a:srgbClr val="00FD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11" name="Rectangle 210">
              <a:extLst>
                <a:ext uri="{FF2B5EF4-FFF2-40B4-BE49-F238E27FC236}">
                  <a16:creationId xmlns:a16="http://schemas.microsoft.com/office/drawing/2014/main" id="{6EC4AA36-0010-124D-9947-18E3D87900FC}"/>
                </a:ext>
              </a:extLst>
            </p:cNvPr>
            <p:cNvSpPr/>
            <p:nvPr/>
          </p:nvSpPr>
          <p:spPr>
            <a:xfrm>
              <a:off x="8777211" y="1266700"/>
              <a:ext cx="60960" cy="228600"/>
            </a:xfrm>
            <a:prstGeom prst="rect">
              <a:avLst/>
            </a:prstGeom>
            <a:solidFill>
              <a:srgbClr val="9437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7A4F49BB-5D57-4E4C-BDEA-2B563C048C26}"/>
              </a:ext>
            </a:extLst>
          </p:cNvPr>
          <p:cNvGrpSpPr/>
          <p:nvPr/>
        </p:nvGrpSpPr>
        <p:grpSpPr>
          <a:xfrm>
            <a:off x="451529" y="1843306"/>
            <a:ext cx="5974733" cy="228600"/>
            <a:chOff x="451529" y="1843306"/>
            <a:chExt cx="5974733" cy="228600"/>
          </a:xfrm>
        </p:grpSpPr>
        <p:sp>
          <p:nvSpPr>
            <p:cNvPr id="237" name="Rectangle 236">
              <a:extLst>
                <a:ext uri="{FF2B5EF4-FFF2-40B4-BE49-F238E27FC236}">
                  <a16:creationId xmlns:a16="http://schemas.microsoft.com/office/drawing/2014/main" id="{9C70A6B7-1F0C-5742-9742-950F22DD37AF}"/>
                </a:ext>
              </a:extLst>
            </p:cNvPr>
            <p:cNvSpPr/>
            <p:nvPr/>
          </p:nvSpPr>
          <p:spPr>
            <a:xfrm>
              <a:off x="451529" y="1843306"/>
              <a:ext cx="36576" cy="228600"/>
            </a:xfrm>
            <a:prstGeom prst="rect">
              <a:avLst/>
            </a:prstGeom>
            <a:solidFill>
              <a:srgbClr val="FF7E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238" name="Rectangle 237">
              <a:extLst>
                <a:ext uri="{FF2B5EF4-FFF2-40B4-BE49-F238E27FC236}">
                  <a16:creationId xmlns:a16="http://schemas.microsoft.com/office/drawing/2014/main" id="{99537C7D-5062-4049-8D27-99736892554F}"/>
                </a:ext>
              </a:extLst>
            </p:cNvPr>
            <p:cNvSpPr/>
            <p:nvPr/>
          </p:nvSpPr>
          <p:spPr>
            <a:xfrm>
              <a:off x="484909" y="1843306"/>
              <a:ext cx="829056" cy="228600"/>
            </a:xfrm>
            <a:prstGeom prst="rect">
              <a:avLst/>
            </a:prstGeom>
            <a:solidFill>
              <a:srgbClr val="FF26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240" name="Rectangle 239">
              <a:extLst>
                <a:ext uri="{FF2B5EF4-FFF2-40B4-BE49-F238E27FC236}">
                  <a16:creationId xmlns:a16="http://schemas.microsoft.com/office/drawing/2014/main" id="{FE434426-F5A5-8249-8C5F-8F46B329CD1E}"/>
                </a:ext>
              </a:extLst>
            </p:cNvPr>
            <p:cNvSpPr/>
            <p:nvPr/>
          </p:nvSpPr>
          <p:spPr>
            <a:xfrm>
              <a:off x="131076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1" name="Rectangle 240">
              <a:extLst>
                <a:ext uri="{FF2B5EF4-FFF2-40B4-BE49-F238E27FC236}">
                  <a16:creationId xmlns:a16="http://schemas.microsoft.com/office/drawing/2014/main" id="{2B18DD88-7C18-E94D-9772-A69D9A78BA97}"/>
                </a:ext>
              </a:extLst>
            </p:cNvPr>
            <p:cNvSpPr/>
            <p:nvPr/>
          </p:nvSpPr>
          <p:spPr>
            <a:xfrm>
              <a:off x="139926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2" name="Rectangle 241">
              <a:extLst>
                <a:ext uri="{FF2B5EF4-FFF2-40B4-BE49-F238E27FC236}">
                  <a16:creationId xmlns:a16="http://schemas.microsoft.com/office/drawing/2014/main" id="{5B67FA09-4B92-A348-9751-0D9B58166A87}"/>
                </a:ext>
              </a:extLst>
            </p:cNvPr>
            <p:cNvSpPr/>
            <p:nvPr/>
          </p:nvSpPr>
          <p:spPr>
            <a:xfrm>
              <a:off x="149411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3" name="Rectangle 242">
              <a:extLst>
                <a:ext uri="{FF2B5EF4-FFF2-40B4-BE49-F238E27FC236}">
                  <a16:creationId xmlns:a16="http://schemas.microsoft.com/office/drawing/2014/main" id="{15A2421F-3CE1-6442-8D74-C0F00A7BCA9E}"/>
                </a:ext>
              </a:extLst>
            </p:cNvPr>
            <p:cNvSpPr/>
            <p:nvPr/>
          </p:nvSpPr>
          <p:spPr>
            <a:xfrm>
              <a:off x="158896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4" name="Rectangle 243">
              <a:extLst>
                <a:ext uri="{FF2B5EF4-FFF2-40B4-BE49-F238E27FC236}">
                  <a16:creationId xmlns:a16="http://schemas.microsoft.com/office/drawing/2014/main" id="{236EFF94-6FF9-FD44-BA03-135283C21D41}"/>
                </a:ext>
              </a:extLst>
            </p:cNvPr>
            <p:cNvSpPr/>
            <p:nvPr/>
          </p:nvSpPr>
          <p:spPr>
            <a:xfrm>
              <a:off x="169016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5" name="Rectangle 244">
              <a:extLst>
                <a:ext uri="{FF2B5EF4-FFF2-40B4-BE49-F238E27FC236}">
                  <a16:creationId xmlns:a16="http://schemas.microsoft.com/office/drawing/2014/main" id="{2C80DEA9-A087-D14E-A041-2647DB44993E}"/>
                </a:ext>
              </a:extLst>
            </p:cNvPr>
            <p:cNvSpPr/>
            <p:nvPr/>
          </p:nvSpPr>
          <p:spPr>
            <a:xfrm>
              <a:off x="178500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6" name="Rectangle 245">
              <a:extLst>
                <a:ext uri="{FF2B5EF4-FFF2-40B4-BE49-F238E27FC236}">
                  <a16:creationId xmlns:a16="http://schemas.microsoft.com/office/drawing/2014/main" id="{55ACFE85-9EE0-CC4A-847F-00AC21F16E60}"/>
                </a:ext>
              </a:extLst>
            </p:cNvPr>
            <p:cNvSpPr/>
            <p:nvPr/>
          </p:nvSpPr>
          <p:spPr>
            <a:xfrm>
              <a:off x="187985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7" name="Rectangle 246">
              <a:extLst>
                <a:ext uri="{FF2B5EF4-FFF2-40B4-BE49-F238E27FC236}">
                  <a16:creationId xmlns:a16="http://schemas.microsoft.com/office/drawing/2014/main" id="{BEA6DD24-A8BB-544A-9751-A204273BCF6F}"/>
                </a:ext>
              </a:extLst>
            </p:cNvPr>
            <p:cNvSpPr/>
            <p:nvPr/>
          </p:nvSpPr>
          <p:spPr>
            <a:xfrm>
              <a:off x="198105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8" name="Rectangle 247">
              <a:extLst>
                <a:ext uri="{FF2B5EF4-FFF2-40B4-BE49-F238E27FC236}">
                  <a16:creationId xmlns:a16="http://schemas.microsoft.com/office/drawing/2014/main" id="{18ED6190-51AF-F942-BABE-6A330BD7FAB0}"/>
                </a:ext>
              </a:extLst>
            </p:cNvPr>
            <p:cNvSpPr/>
            <p:nvPr/>
          </p:nvSpPr>
          <p:spPr>
            <a:xfrm>
              <a:off x="208225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49" name="Rectangle 248">
              <a:extLst>
                <a:ext uri="{FF2B5EF4-FFF2-40B4-BE49-F238E27FC236}">
                  <a16:creationId xmlns:a16="http://schemas.microsoft.com/office/drawing/2014/main" id="{D8B08930-739D-1E47-B0B7-0D17A2A0FF0A}"/>
                </a:ext>
              </a:extLst>
            </p:cNvPr>
            <p:cNvSpPr/>
            <p:nvPr/>
          </p:nvSpPr>
          <p:spPr>
            <a:xfrm>
              <a:off x="217710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0" name="Rectangle 249">
              <a:extLst>
                <a:ext uri="{FF2B5EF4-FFF2-40B4-BE49-F238E27FC236}">
                  <a16:creationId xmlns:a16="http://schemas.microsoft.com/office/drawing/2014/main" id="{EE268243-8AF4-5E4A-B046-1885A1F47F2E}"/>
                </a:ext>
              </a:extLst>
            </p:cNvPr>
            <p:cNvSpPr/>
            <p:nvPr/>
          </p:nvSpPr>
          <p:spPr>
            <a:xfrm>
              <a:off x="227194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1" name="Rectangle 250">
              <a:extLst>
                <a:ext uri="{FF2B5EF4-FFF2-40B4-BE49-F238E27FC236}">
                  <a16:creationId xmlns:a16="http://schemas.microsoft.com/office/drawing/2014/main" id="{2C730969-51A3-7149-8677-52544A3304E1}"/>
                </a:ext>
              </a:extLst>
            </p:cNvPr>
            <p:cNvSpPr/>
            <p:nvPr/>
          </p:nvSpPr>
          <p:spPr>
            <a:xfrm>
              <a:off x="236679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2" name="Rectangle 251">
              <a:extLst>
                <a:ext uri="{FF2B5EF4-FFF2-40B4-BE49-F238E27FC236}">
                  <a16:creationId xmlns:a16="http://schemas.microsoft.com/office/drawing/2014/main" id="{F7D44CB5-2F7B-5A4E-ABD7-BA5DB9361FEB}"/>
                </a:ext>
              </a:extLst>
            </p:cNvPr>
            <p:cNvSpPr/>
            <p:nvPr/>
          </p:nvSpPr>
          <p:spPr>
            <a:xfrm>
              <a:off x="245529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3" name="Rectangle 252">
              <a:extLst>
                <a:ext uri="{FF2B5EF4-FFF2-40B4-BE49-F238E27FC236}">
                  <a16:creationId xmlns:a16="http://schemas.microsoft.com/office/drawing/2014/main" id="{99E76684-74BD-674C-B50C-D374CE4F8B0B}"/>
                </a:ext>
              </a:extLst>
            </p:cNvPr>
            <p:cNvSpPr/>
            <p:nvPr/>
          </p:nvSpPr>
          <p:spPr>
            <a:xfrm>
              <a:off x="254379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4" name="Rectangle 253">
              <a:extLst>
                <a:ext uri="{FF2B5EF4-FFF2-40B4-BE49-F238E27FC236}">
                  <a16:creationId xmlns:a16="http://schemas.microsoft.com/office/drawing/2014/main" id="{1E5BFE5D-08C7-0E46-ADE8-764BA427C43E}"/>
                </a:ext>
              </a:extLst>
            </p:cNvPr>
            <p:cNvSpPr/>
            <p:nvPr/>
          </p:nvSpPr>
          <p:spPr>
            <a:xfrm>
              <a:off x="263864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89B5B30F-5F76-F048-BD78-15D9A279F953}"/>
                </a:ext>
              </a:extLst>
            </p:cNvPr>
            <p:cNvSpPr/>
            <p:nvPr/>
          </p:nvSpPr>
          <p:spPr>
            <a:xfrm>
              <a:off x="273348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6" name="Rectangle 255">
              <a:extLst>
                <a:ext uri="{FF2B5EF4-FFF2-40B4-BE49-F238E27FC236}">
                  <a16:creationId xmlns:a16="http://schemas.microsoft.com/office/drawing/2014/main" id="{B537BE2F-18A4-7A4B-9829-3F5CD15CC2A0}"/>
                </a:ext>
              </a:extLst>
            </p:cNvPr>
            <p:cNvSpPr/>
            <p:nvPr/>
          </p:nvSpPr>
          <p:spPr>
            <a:xfrm>
              <a:off x="282833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7" name="Rectangle 256">
              <a:extLst>
                <a:ext uri="{FF2B5EF4-FFF2-40B4-BE49-F238E27FC236}">
                  <a16:creationId xmlns:a16="http://schemas.microsoft.com/office/drawing/2014/main" id="{DB161A0D-CFF3-B548-AE99-E3638E503B05}"/>
                </a:ext>
              </a:extLst>
            </p:cNvPr>
            <p:cNvSpPr/>
            <p:nvPr/>
          </p:nvSpPr>
          <p:spPr>
            <a:xfrm>
              <a:off x="292318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19162147-B251-8543-8FF1-BD285B7CB61E}"/>
                </a:ext>
              </a:extLst>
            </p:cNvPr>
            <p:cNvSpPr/>
            <p:nvPr/>
          </p:nvSpPr>
          <p:spPr>
            <a:xfrm>
              <a:off x="301803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59" name="Rectangle 258">
              <a:extLst>
                <a:ext uri="{FF2B5EF4-FFF2-40B4-BE49-F238E27FC236}">
                  <a16:creationId xmlns:a16="http://schemas.microsoft.com/office/drawing/2014/main" id="{0565DCF4-F9D7-8947-A620-5EC19D694A70}"/>
                </a:ext>
              </a:extLst>
            </p:cNvPr>
            <p:cNvSpPr/>
            <p:nvPr/>
          </p:nvSpPr>
          <p:spPr>
            <a:xfrm>
              <a:off x="311288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40ACDC38-96F6-1248-A755-6AB6B165FDDC}"/>
                </a:ext>
              </a:extLst>
            </p:cNvPr>
            <p:cNvSpPr/>
            <p:nvPr/>
          </p:nvSpPr>
          <p:spPr>
            <a:xfrm>
              <a:off x="320772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1" name="Rectangle 260">
              <a:extLst>
                <a:ext uri="{FF2B5EF4-FFF2-40B4-BE49-F238E27FC236}">
                  <a16:creationId xmlns:a16="http://schemas.microsoft.com/office/drawing/2014/main" id="{E9627371-3047-9D4A-B70A-E6C780435FAB}"/>
                </a:ext>
              </a:extLst>
            </p:cNvPr>
            <p:cNvSpPr/>
            <p:nvPr/>
          </p:nvSpPr>
          <p:spPr>
            <a:xfrm>
              <a:off x="330257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2" name="Rectangle 261">
              <a:extLst>
                <a:ext uri="{FF2B5EF4-FFF2-40B4-BE49-F238E27FC236}">
                  <a16:creationId xmlns:a16="http://schemas.microsoft.com/office/drawing/2014/main" id="{EB2F0DF1-0040-4A4B-93B5-49E632CFC1FB}"/>
                </a:ext>
              </a:extLst>
            </p:cNvPr>
            <p:cNvSpPr/>
            <p:nvPr/>
          </p:nvSpPr>
          <p:spPr>
            <a:xfrm>
              <a:off x="339742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3" name="Rectangle 262">
              <a:extLst>
                <a:ext uri="{FF2B5EF4-FFF2-40B4-BE49-F238E27FC236}">
                  <a16:creationId xmlns:a16="http://schemas.microsoft.com/office/drawing/2014/main" id="{CDA332E9-47E3-0343-9479-41BC313F56FA}"/>
                </a:ext>
              </a:extLst>
            </p:cNvPr>
            <p:cNvSpPr/>
            <p:nvPr/>
          </p:nvSpPr>
          <p:spPr>
            <a:xfrm>
              <a:off x="349862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4" name="Rectangle 263">
              <a:extLst>
                <a:ext uri="{FF2B5EF4-FFF2-40B4-BE49-F238E27FC236}">
                  <a16:creationId xmlns:a16="http://schemas.microsoft.com/office/drawing/2014/main" id="{1CE82F89-EBBE-E04C-A0F0-8EBCD75417F2}"/>
                </a:ext>
              </a:extLst>
            </p:cNvPr>
            <p:cNvSpPr/>
            <p:nvPr/>
          </p:nvSpPr>
          <p:spPr>
            <a:xfrm>
              <a:off x="359982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5" name="Rectangle 264">
              <a:extLst>
                <a:ext uri="{FF2B5EF4-FFF2-40B4-BE49-F238E27FC236}">
                  <a16:creationId xmlns:a16="http://schemas.microsoft.com/office/drawing/2014/main" id="{8E9828C9-6E36-FF4C-88CF-F1C2C823358E}"/>
                </a:ext>
              </a:extLst>
            </p:cNvPr>
            <p:cNvSpPr/>
            <p:nvPr/>
          </p:nvSpPr>
          <p:spPr>
            <a:xfrm>
              <a:off x="369466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6" name="Rectangle 265">
              <a:extLst>
                <a:ext uri="{FF2B5EF4-FFF2-40B4-BE49-F238E27FC236}">
                  <a16:creationId xmlns:a16="http://schemas.microsoft.com/office/drawing/2014/main" id="{F14E29AB-94FE-E346-B986-445555ACA88A}"/>
                </a:ext>
              </a:extLst>
            </p:cNvPr>
            <p:cNvSpPr/>
            <p:nvPr/>
          </p:nvSpPr>
          <p:spPr>
            <a:xfrm>
              <a:off x="378951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7" name="Rectangle 266">
              <a:extLst>
                <a:ext uri="{FF2B5EF4-FFF2-40B4-BE49-F238E27FC236}">
                  <a16:creationId xmlns:a16="http://schemas.microsoft.com/office/drawing/2014/main" id="{1C6F5E3D-72D6-9B43-A26F-FBDD009C9090}"/>
                </a:ext>
              </a:extLst>
            </p:cNvPr>
            <p:cNvSpPr/>
            <p:nvPr/>
          </p:nvSpPr>
          <p:spPr>
            <a:xfrm>
              <a:off x="388436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8" name="Rectangle 267">
              <a:extLst>
                <a:ext uri="{FF2B5EF4-FFF2-40B4-BE49-F238E27FC236}">
                  <a16:creationId xmlns:a16="http://schemas.microsoft.com/office/drawing/2014/main" id="{D6F54485-BE22-954A-AB3D-1E3D5F6B07FD}"/>
                </a:ext>
              </a:extLst>
            </p:cNvPr>
            <p:cNvSpPr/>
            <p:nvPr/>
          </p:nvSpPr>
          <p:spPr>
            <a:xfrm>
              <a:off x="397921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69" name="Rectangle 268">
              <a:extLst>
                <a:ext uri="{FF2B5EF4-FFF2-40B4-BE49-F238E27FC236}">
                  <a16:creationId xmlns:a16="http://schemas.microsoft.com/office/drawing/2014/main" id="{1DBFCB14-939B-3140-BECA-E8BB735FDE27}"/>
                </a:ext>
              </a:extLst>
            </p:cNvPr>
            <p:cNvSpPr/>
            <p:nvPr/>
          </p:nvSpPr>
          <p:spPr>
            <a:xfrm>
              <a:off x="407406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A644BF4A-7EC7-B740-901E-2111C0345421}"/>
                </a:ext>
              </a:extLst>
            </p:cNvPr>
            <p:cNvSpPr/>
            <p:nvPr/>
          </p:nvSpPr>
          <p:spPr>
            <a:xfrm>
              <a:off x="416890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1" name="Rectangle 270">
              <a:extLst>
                <a:ext uri="{FF2B5EF4-FFF2-40B4-BE49-F238E27FC236}">
                  <a16:creationId xmlns:a16="http://schemas.microsoft.com/office/drawing/2014/main" id="{0345A00B-13CC-2F43-9C8E-7FCA88C5DFBC}"/>
                </a:ext>
              </a:extLst>
            </p:cNvPr>
            <p:cNvSpPr/>
            <p:nvPr/>
          </p:nvSpPr>
          <p:spPr>
            <a:xfrm>
              <a:off x="426375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2D30B496-9157-8A4D-9175-D0272833C251}"/>
                </a:ext>
              </a:extLst>
            </p:cNvPr>
            <p:cNvSpPr/>
            <p:nvPr/>
          </p:nvSpPr>
          <p:spPr>
            <a:xfrm>
              <a:off x="435860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3" name="Rectangle 272">
              <a:extLst>
                <a:ext uri="{FF2B5EF4-FFF2-40B4-BE49-F238E27FC236}">
                  <a16:creationId xmlns:a16="http://schemas.microsoft.com/office/drawing/2014/main" id="{D85F3178-88D0-3643-BE27-5FDABC58152C}"/>
                </a:ext>
              </a:extLst>
            </p:cNvPr>
            <p:cNvSpPr/>
            <p:nvPr/>
          </p:nvSpPr>
          <p:spPr>
            <a:xfrm>
              <a:off x="445345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4" name="Rectangle 273">
              <a:extLst>
                <a:ext uri="{FF2B5EF4-FFF2-40B4-BE49-F238E27FC236}">
                  <a16:creationId xmlns:a16="http://schemas.microsoft.com/office/drawing/2014/main" id="{CF3E8D10-6DD0-0448-BEA2-203887FFDEB8}"/>
                </a:ext>
              </a:extLst>
            </p:cNvPr>
            <p:cNvSpPr/>
            <p:nvPr/>
          </p:nvSpPr>
          <p:spPr>
            <a:xfrm>
              <a:off x="454830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5" name="Rectangle 274">
              <a:extLst>
                <a:ext uri="{FF2B5EF4-FFF2-40B4-BE49-F238E27FC236}">
                  <a16:creationId xmlns:a16="http://schemas.microsoft.com/office/drawing/2014/main" id="{03F85601-8BCB-2F4B-89D1-B236F44EC378}"/>
                </a:ext>
              </a:extLst>
            </p:cNvPr>
            <p:cNvSpPr/>
            <p:nvPr/>
          </p:nvSpPr>
          <p:spPr>
            <a:xfrm>
              <a:off x="464314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6" name="Rectangle 275">
              <a:extLst>
                <a:ext uri="{FF2B5EF4-FFF2-40B4-BE49-F238E27FC236}">
                  <a16:creationId xmlns:a16="http://schemas.microsoft.com/office/drawing/2014/main" id="{3AC7E3CA-5F7D-7949-B0E1-3BFFAF97706D}"/>
                </a:ext>
              </a:extLst>
            </p:cNvPr>
            <p:cNvSpPr/>
            <p:nvPr/>
          </p:nvSpPr>
          <p:spPr>
            <a:xfrm>
              <a:off x="473799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7" name="Rectangle 276">
              <a:extLst>
                <a:ext uri="{FF2B5EF4-FFF2-40B4-BE49-F238E27FC236}">
                  <a16:creationId xmlns:a16="http://schemas.microsoft.com/office/drawing/2014/main" id="{A32E2152-0A2D-DE4E-ACCE-6D3DAD835169}"/>
                </a:ext>
              </a:extLst>
            </p:cNvPr>
            <p:cNvSpPr/>
            <p:nvPr/>
          </p:nvSpPr>
          <p:spPr>
            <a:xfrm>
              <a:off x="483284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8" name="Rectangle 277">
              <a:extLst>
                <a:ext uri="{FF2B5EF4-FFF2-40B4-BE49-F238E27FC236}">
                  <a16:creationId xmlns:a16="http://schemas.microsoft.com/office/drawing/2014/main" id="{956C1F9C-50B1-D84E-AC35-F6AC44A37EDE}"/>
                </a:ext>
              </a:extLst>
            </p:cNvPr>
            <p:cNvSpPr/>
            <p:nvPr/>
          </p:nvSpPr>
          <p:spPr>
            <a:xfrm>
              <a:off x="4927693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79" name="Rectangle 278">
              <a:extLst>
                <a:ext uri="{FF2B5EF4-FFF2-40B4-BE49-F238E27FC236}">
                  <a16:creationId xmlns:a16="http://schemas.microsoft.com/office/drawing/2014/main" id="{0C339FA3-555C-DF47-A893-E71A727A7298}"/>
                </a:ext>
              </a:extLst>
            </p:cNvPr>
            <p:cNvSpPr/>
            <p:nvPr/>
          </p:nvSpPr>
          <p:spPr>
            <a:xfrm>
              <a:off x="5022541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80" name="Rectangle 279">
              <a:extLst>
                <a:ext uri="{FF2B5EF4-FFF2-40B4-BE49-F238E27FC236}">
                  <a16:creationId xmlns:a16="http://schemas.microsoft.com/office/drawing/2014/main" id="{71C076FA-11CA-364C-A884-45D03C74D743}"/>
                </a:ext>
              </a:extLst>
            </p:cNvPr>
            <p:cNvSpPr/>
            <p:nvPr/>
          </p:nvSpPr>
          <p:spPr>
            <a:xfrm>
              <a:off x="5117389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81" name="Rectangle 280">
              <a:extLst>
                <a:ext uri="{FF2B5EF4-FFF2-40B4-BE49-F238E27FC236}">
                  <a16:creationId xmlns:a16="http://schemas.microsoft.com/office/drawing/2014/main" id="{FA096614-58AE-4744-B74D-3B7B473F2913}"/>
                </a:ext>
              </a:extLst>
            </p:cNvPr>
            <p:cNvSpPr/>
            <p:nvPr/>
          </p:nvSpPr>
          <p:spPr>
            <a:xfrm>
              <a:off x="5212237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82" name="Rectangle 281">
              <a:extLst>
                <a:ext uri="{FF2B5EF4-FFF2-40B4-BE49-F238E27FC236}">
                  <a16:creationId xmlns:a16="http://schemas.microsoft.com/office/drawing/2014/main" id="{A313726D-6188-5C49-BA03-843C07481E2D}"/>
                </a:ext>
              </a:extLst>
            </p:cNvPr>
            <p:cNvSpPr/>
            <p:nvPr/>
          </p:nvSpPr>
          <p:spPr>
            <a:xfrm>
              <a:off x="5307085" y="1843306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99" name="Rectangle 298">
              <a:extLst>
                <a:ext uri="{FF2B5EF4-FFF2-40B4-BE49-F238E27FC236}">
                  <a16:creationId xmlns:a16="http://schemas.microsoft.com/office/drawing/2014/main" id="{38AD0ECD-DA90-D341-B0D1-E821DA334FEE}"/>
                </a:ext>
              </a:extLst>
            </p:cNvPr>
            <p:cNvSpPr/>
            <p:nvPr/>
          </p:nvSpPr>
          <p:spPr>
            <a:xfrm>
              <a:off x="5401933" y="1843306"/>
              <a:ext cx="743712" cy="228600"/>
            </a:xfrm>
            <a:prstGeom prst="rect">
              <a:avLst/>
            </a:prstGeom>
            <a:solidFill>
              <a:srgbClr val="73FB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00" name="Rectangle 299">
              <a:extLst>
                <a:ext uri="{FF2B5EF4-FFF2-40B4-BE49-F238E27FC236}">
                  <a16:creationId xmlns:a16="http://schemas.microsoft.com/office/drawing/2014/main" id="{266EB614-F7BE-CC45-9A23-EDF95BB37B8E}"/>
                </a:ext>
              </a:extLst>
            </p:cNvPr>
            <p:cNvSpPr/>
            <p:nvPr/>
          </p:nvSpPr>
          <p:spPr>
            <a:xfrm>
              <a:off x="6148799" y="1843306"/>
              <a:ext cx="219456" cy="228600"/>
            </a:xfrm>
            <a:prstGeom prst="rect">
              <a:avLst/>
            </a:prstGeom>
            <a:solidFill>
              <a:srgbClr val="00FD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01" name="Rectangle 300">
              <a:extLst>
                <a:ext uri="{FF2B5EF4-FFF2-40B4-BE49-F238E27FC236}">
                  <a16:creationId xmlns:a16="http://schemas.microsoft.com/office/drawing/2014/main" id="{28E8E0BF-DBFB-3940-BC32-8675C4B71D6E}"/>
                </a:ext>
              </a:extLst>
            </p:cNvPr>
            <p:cNvSpPr/>
            <p:nvPr/>
          </p:nvSpPr>
          <p:spPr>
            <a:xfrm>
              <a:off x="6371398" y="1843306"/>
              <a:ext cx="54864" cy="228600"/>
            </a:xfrm>
            <a:prstGeom prst="rect">
              <a:avLst/>
            </a:prstGeom>
            <a:solidFill>
              <a:srgbClr val="9437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3D18C60D-BD48-4B32-9EF1-790D9C22F62B}"/>
              </a:ext>
            </a:extLst>
          </p:cNvPr>
          <p:cNvGrpSpPr/>
          <p:nvPr/>
        </p:nvGrpSpPr>
        <p:grpSpPr>
          <a:xfrm>
            <a:off x="364454" y="552615"/>
            <a:ext cx="8049229" cy="2852274"/>
            <a:chOff x="364454" y="552615"/>
            <a:chExt cx="8049229" cy="285227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05C592D-02B3-4DF7-AD6F-46E6D95BB339}"/>
                </a:ext>
              </a:extLst>
            </p:cNvPr>
            <p:cNvGrpSpPr/>
            <p:nvPr/>
          </p:nvGrpSpPr>
          <p:grpSpPr>
            <a:xfrm>
              <a:off x="6929865" y="1649242"/>
              <a:ext cx="1483818" cy="1755647"/>
              <a:chOff x="6929865" y="1649242"/>
              <a:chExt cx="1483818" cy="1755647"/>
            </a:xfrm>
          </p:grpSpPr>
          <p:sp>
            <p:nvSpPr>
              <p:cNvPr id="213" name="Rectangle 212">
                <a:extLst>
                  <a:ext uri="{FF2B5EF4-FFF2-40B4-BE49-F238E27FC236}">
                    <a16:creationId xmlns:a16="http://schemas.microsoft.com/office/drawing/2014/main" id="{85D82ECA-64C8-364E-B94A-3E9EB2090B81}"/>
                  </a:ext>
                </a:extLst>
              </p:cNvPr>
              <p:cNvSpPr/>
              <p:nvPr/>
            </p:nvSpPr>
            <p:spPr>
              <a:xfrm>
                <a:off x="6929865" y="1680764"/>
                <a:ext cx="152400" cy="1524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4" name="Rectangle 213">
                <a:extLst>
                  <a:ext uri="{FF2B5EF4-FFF2-40B4-BE49-F238E27FC236}">
                    <a16:creationId xmlns:a16="http://schemas.microsoft.com/office/drawing/2014/main" id="{BB3B86EC-4D9B-2D4D-8275-021DC2AE36F2}"/>
                  </a:ext>
                </a:extLst>
              </p:cNvPr>
              <p:cNvSpPr/>
              <p:nvPr/>
            </p:nvSpPr>
            <p:spPr>
              <a:xfrm>
                <a:off x="6929865" y="1869937"/>
                <a:ext cx="152400" cy="1524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5" name="Rectangle 214">
                <a:extLst>
                  <a:ext uri="{FF2B5EF4-FFF2-40B4-BE49-F238E27FC236}">
                    <a16:creationId xmlns:a16="http://schemas.microsoft.com/office/drawing/2014/main" id="{F8A78A56-44C0-1543-B7BB-40FC448D493A}"/>
                  </a:ext>
                </a:extLst>
              </p:cNvPr>
              <p:cNvSpPr/>
              <p:nvPr/>
            </p:nvSpPr>
            <p:spPr>
              <a:xfrm>
                <a:off x="6929865" y="2064871"/>
                <a:ext cx="152400" cy="1524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6" name="Rectangle 215">
                <a:extLst>
                  <a:ext uri="{FF2B5EF4-FFF2-40B4-BE49-F238E27FC236}">
                    <a16:creationId xmlns:a16="http://schemas.microsoft.com/office/drawing/2014/main" id="{19E874DD-9764-0042-BE1A-3A732A05C200}"/>
                  </a:ext>
                </a:extLst>
              </p:cNvPr>
              <p:cNvSpPr/>
              <p:nvPr/>
            </p:nvSpPr>
            <p:spPr>
              <a:xfrm>
                <a:off x="6929865" y="2260906"/>
                <a:ext cx="152400" cy="152400"/>
              </a:xfrm>
              <a:prstGeom prst="rect">
                <a:avLst/>
              </a:prstGeom>
              <a:solidFill>
                <a:srgbClr val="73FB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7" name="Rectangle 216">
                <a:extLst>
                  <a:ext uri="{FF2B5EF4-FFF2-40B4-BE49-F238E27FC236}">
                    <a16:creationId xmlns:a16="http://schemas.microsoft.com/office/drawing/2014/main" id="{575FE7AE-1F2C-AD42-81C0-990EA16BD30A}"/>
                  </a:ext>
                </a:extLst>
              </p:cNvPr>
              <p:cNvSpPr/>
              <p:nvPr/>
            </p:nvSpPr>
            <p:spPr>
              <a:xfrm>
                <a:off x="6929865" y="2452583"/>
                <a:ext cx="152400" cy="152400"/>
              </a:xfrm>
              <a:prstGeom prst="rect">
                <a:avLst/>
              </a:prstGeom>
              <a:solidFill>
                <a:srgbClr val="00FD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8" name="Rectangle 217">
                <a:extLst>
                  <a:ext uri="{FF2B5EF4-FFF2-40B4-BE49-F238E27FC236}">
                    <a16:creationId xmlns:a16="http://schemas.microsoft.com/office/drawing/2014/main" id="{61471033-8ADD-AE47-942B-7255AC6C78CE}"/>
                  </a:ext>
                </a:extLst>
              </p:cNvPr>
              <p:cNvSpPr/>
              <p:nvPr/>
            </p:nvSpPr>
            <p:spPr>
              <a:xfrm>
                <a:off x="6929865" y="2640871"/>
                <a:ext cx="152400" cy="152400"/>
              </a:xfrm>
              <a:prstGeom prst="rect">
                <a:avLst/>
              </a:prstGeom>
              <a:solidFill>
                <a:srgbClr val="0096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9" name="Rectangle 218">
                <a:extLst>
                  <a:ext uri="{FF2B5EF4-FFF2-40B4-BE49-F238E27FC236}">
                    <a16:creationId xmlns:a16="http://schemas.microsoft.com/office/drawing/2014/main" id="{508E4FDC-86FD-3841-8F25-E5C77E3BD5C2}"/>
                  </a:ext>
                </a:extLst>
              </p:cNvPr>
              <p:cNvSpPr/>
              <p:nvPr/>
            </p:nvSpPr>
            <p:spPr>
              <a:xfrm>
                <a:off x="6929865" y="2832548"/>
                <a:ext cx="152400" cy="152400"/>
              </a:xfrm>
              <a:prstGeom prst="rect">
                <a:avLst/>
              </a:prstGeom>
              <a:solidFill>
                <a:srgbClr val="0432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20" name="Rectangle 219">
                <a:extLst>
                  <a:ext uri="{FF2B5EF4-FFF2-40B4-BE49-F238E27FC236}">
                    <a16:creationId xmlns:a16="http://schemas.microsoft.com/office/drawing/2014/main" id="{1CD43185-18AF-F54C-A379-C13E28EA963F}"/>
                  </a:ext>
                </a:extLst>
              </p:cNvPr>
              <p:cNvSpPr/>
              <p:nvPr/>
            </p:nvSpPr>
            <p:spPr>
              <a:xfrm>
                <a:off x="6929865" y="3024225"/>
                <a:ext cx="152400" cy="152400"/>
              </a:xfrm>
              <a:prstGeom prst="rect">
                <a:avLst/>
              </a:prstGeom>
              <a:solidFill>
                <a:srgbClr val="FF40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21" name="Rectangle 220">
                <a:extLst>
                  <a:ext uri="{FF2B5EF4-FFF2-40B4-BE49-F238E27FC236}">
                    <a16:creationId xmlns:a16="http://schemas.microsoft.com/office/drawing/2014/main" id="{4FFF5BFC-BE96-AA46-AFE3-89F16477E32D}"/>
                  </a:ext>
                </a:extLst>
              </p:cNvPr>
              <p:cNvSpPr/>
              <p:nvPr/>
            </p:nvSpPr>
            <p:spPr>
              <a:xfrm>
                <a:off x="6929865" y="3220967"/>
                <a:ext cx="152400" cy="1524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9BC578EC-8622-FB44-A5AC-C9170AC276CE}"/>
                  </a:ext>
                </a:extLst>
              </p:cNvPr>
              <p:cNvSpPr txBox="1"/>
              <p:nvPr/>
            </p:nvSpPr>
            <p:spPr>
              <a:xfrm>
                <a:off x="7092487" y="1649242"/>
                <a:ext cx="1321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ecretory Signal Peptide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F65B413F-95AC-7443-B13B-471F96D74DFE}"/>
                  </a:ext>
                </a:extLst>
              </p:cNvPr>
              <p:cNvSpPr txBox="1"/>
              <p:nvPr/>
            </p:nvSpPr>
            <p:spPr>
              <a:xfrm>
                <a:off x="7092487" y="1838415"/>
                <a:ext cx="6142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T-Als + </a:t>
                </a: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C07241EF-8DD4-FF44-8F99-E9CE27F1A3A8}"/>
                  </a:ext>
                </a:extLst>
              </p:cNvPr>
              <p:cNvSpPr txBox="1"/>
              <p:nvPr/>
            </p:nvSpPr>
            <p:spPr>
              <a:xfrm>
                <a:off x="7092487" y="2033349"/>
                <a:ext cx="9765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ndem Repeats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D7BCF7AB-F974-6E4C-9E21-9F49BE335C79}"/>
                  </a:ext>
                </a:extLst>
              </p:cNvPr>
              <p:cNvSpPr txBox="1"/>
              <p:nvPr/>
            </p:nvSpPr>
            <p:spPr>
              <a:xfrm>
                <a:off x="7092487" y="2229384"/>
                <a:ext cx="58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76565A3D-9FD9-5147-95F0-756FB4CF198F}"/>
                  </a:ext>
                </a:extLst>
              </p:cNvPr>
              <p:cNvSpPr txBox="1"/>
              <p:nvPr/>
            </p:nvSpPr>
            <p:spPr>
              <a:xfrm>
                <a:off x="7092487" y="2421061"/>
                <a:ext cx="64633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NS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D3AEA6F3-0062-8248-9A53-95D7E2B3A3E2}"/>
                  </a:ext>
                </a:extLst>
              </p:cNvPr>
              <p:cNvSpPr txBox="1"/>
              <p:nvPr/>
            </p:nvSpPr>
            <p:spPr>
              <a:xfrm>
                <a:off x="7092487" y="3189445"/>
                <a:ext cx="97174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PI Addition Site</a:t>
                </a: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6203B029-4A67-7241-9A4B-9EC4EA617B98}"/>
                  </a:ext>
                </a:extLst>
              </p:cNvPr>
              <p:cNvSpPr txBox="1"/>
              <p:nvPr/>
            </p:nvSpPr>
            <p:spPr>
              <a:xfrm>
                <a:off x="7092487" y="2609349"/>
                <a:ext cx="6030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VPTGP</a:t>
                </a: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16676433-C7D9-7B4C-A42E-7F6A4E28D745}"/>
                  </a:ext>
                </a:extLst>
              </p:cNvPr>
              <p:cNvSpPr txBox="1"/>
              <p:nvPr/>
            </p:nvSpPr>
            <p:spPr>
              <a:xfrm>
                <a:off x="7092487" y="2801026"/>
                <a:ext cx="7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8F5FDF49-CDD7-9F4E-B9E7-E9805977E4E8}"/>
                  </a:ext>
                </a:extLst>
              </p:cNvPr>
              <p:cNvSpPr txBox="1"/>
              <p:nvPr/>
            </p:nvSpPr>
            <p:spPr>
              <a:xfrm>
                <a:off x="7092487" y="2992703"/>
                <a:ext cx="62388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PT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</p:grp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5714C15C-920D-A44B-AFC5-6FBA20766FD8}"/>
                </a:ext>
              </a:extLst>
            </p:cNvPr>
            <p:cNvSpPr txBox="1"/>
            <p:nvPr/>
          </p:nvSpPr>
          <p:spPr>
            <a:xfrm>
              <a:off x="364454" y="1071539"/>
              <a:ext cx="8515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gAls2302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B71E76C7-CB75-1044-8EB6-D3552773A2E5}"/>
                </a:ext>
              </a:extLst>
            </p:cNvPr>
            <p:cNvSpPr txBox="1"/>
            <p:nvPr/>
          </p:nvSpPr>
          <p:spPr>
            <a:xfrm>
              <a:off x="364454" y="1638998"/>
              <a:ext cx="8515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gAls3259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AF3BE8F0-B102-1B43-9351-8D93E5A7A09E}"/>
                </a:ext>
              </a:extLst>
            </p:cNvPr>
            <p:cNvSpPr txBox="1"/>
            <p:nvPr/>
          </p:nvSpPr>
          <p:spPr>
            <a:xfrm>
              <a:off x="364454" y="2195250"/>
              <a:ext cx="8515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gAls3330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8C7D9870-0076-9340-B162-9902FD580602}"/>
                </a:ext>
              </a:extLst>
            </p:cNvPr>
            <p:cNvSpPr txBox="1"/>
            <p:nvPr/>
          </p:nvSpPr>
          <p:spPr>
            <a:xfrm>
              <a:off x="364454" y="556081"/>
              <a:ext cx="8162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gAls673 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7B2D0E5F-1256-4D60-8799-53E8E4216219}"/>
                </a:ext>
              </a:extLst>
            </p:cNvPr>
            <p:cNvGrpSpPr/>
            <p:nvPr/>
          </p:nvGrpSpPr>
          <p:grpSpPr>
            <a:xfrm>
              <a:off x="451529" y="2397141"/>
              <a:ext cx="4640680" cy="228600"/>
              <a:chOff x="358335" y="3307793"/>
              <a:chExt cx="4640680" cy="228600"/>
            </a:xfrm>
          </p:grpSpPr>
          <p:sp>
            <p:nvSpPr>
              <p:cNvPr id="302" name="Rectangle 301">
                <a:extLst>
                  <a:ext uri="{FF2B5EF4-FFF2-40B4-BE49-F238E27FC236}">
                    <a16:creationId xmlns:a16="http://schemas.microsoft.com/office/drawing/2014/main" id="{5EBEC098-BEDE-C048-9483-573D0A1F313C}"/>
                  </a:ext>
                </a:extLst>
              </p:cNvPr>
              <p:cNvSpPr/>
              <p:nvPr/>
            </p:nvSpPr>
            <p:spPr>
              <a:xfrm>
                <a:off x="358335" y="3307793"/>
                <a:ext cx="36576" cy="2286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03" name="Rectangle 302">
                <a:extLst>
                  <a:ext uri="{FF2B5EF4-FFF2-40B4-BE49-F238E27FC236}">
                    <a16:creationId xmlns:a16="http://schemas.microsoft.com/office/drawing/2014/main" id="{627671DD-F726-0A4F-A320-3002DFF1AFA8}"/>
                  </a:ext>
                </a:extLst>
              </p:cNvPr>
              <p:cNvSpPr/>
              <p:nvPr/>
            </p:nvSpPr>
            <p:spPr>
              <a:xfrm>
                <a:off x="391004" y="3307793"/>
                <a:ext cx="835152" cy="2286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05" name="Rectangle 304">
                <a:extLst>
                  <a:ext uri="{FF2B5EF4-FFF2-40B4-BE49-F238E27FC236}">
                    <a16:creationId xmlns:a16="http://schemas.microsoft.com/office/drawing/2014/main" id="{B10C6112-FE53-6949-BC57-4E64F37DDB5D}"/>
                  </a:ext>
                </a:extLst>
              </p:cNvPr>
              <p:cNvSpPr/>
              <p:nvPr/>
            </p:nvSpPr>
            <p:spPr>
              <a:xfrm>
                <a:off x="12235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06" name="Rectangle 305">
                <a:extLst>
                  <a:ext uri="{FF2B5EF4-FFF2-40B4-BE49-F238E27FC236}">
                    <a16:creationId xmlns:a16="http://schemas.microsoft.com/office/drawing/2014/main" id="{E5C7510B-3506-FA42-B74C-CC8F9F55524F}"/>
                  </a:ext>
                </a:extLst>
              </p:cNvPr>
              <p:cNvSpPr/>
              <p:nvPr/>
            </p:nvSpPr>
            <p:spPr>
              <a:xfrm>
                <a:off x="13188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07" name="Rectangle 306">
                <a:extLst>
                  <a:ext uri="{FF2B5EF4-FFF2-40B4-BE49-F238E27FC236}">
                    <a16:creationId xmlns:a16="http://schemas.microsoft.com/office/drawing/2014/main" id="{5A049BA4-2887-0249-8DA8-5F3BC38C257E}"/>
                  </a:ext>
                </a:extLst>
              </p:cNvPr>
              <p:cNvSpPr/>
              <p:nvPr/>
            </p:nvSpPr>
            <p:spPr>
              <a:xfrm>
                <a:off x="14140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08" name="Rectangle 307">
                <a:extLst>
                  <a:ext uri="{FF2B5EF4-FFF2-40B4-BE49-F238E27FC236}">
                    <a16:creationId xmlns:a16="http://schemas.microsoft.com/office/drawing/2014/main" id="{8BB82904-4718-FE49-9F8F-FE3EBB34C10A}"/>
                  </a:ext>
                </a:extLst>
              </p:cNvPr>
              <p:cNvSpPr/>
              <p:nvPr/>
            </p:nvSpPr>
            <p:spPr>
              <a:xfrm>
                <a:off x="15093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09" name="Rectangle 308">
                <a:extLst>
                  <a:ext uri="{FF2B5EF4-FFF2-40B4-BE49-F238E27FC236}">
                    <a16:creationId xmlns:a16="http://schemas.microsoft.com/office/drawing/2014/main" id="{C2DF8A43-B881-4F4C-B6DA-FCA77B7E3371}"/>
                  </a:ext>
                </a:extLst>
              </p:cNvPr>
              <p:cNvSpPr/>
              <p:nvPr/>
            </p:nvSpPr>
            <p:spPr>
              <a:xfrm>
                <a:off x="16045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0" name="Rectangle 309">
                <a:extLst>
                  <a:ext uri="{FF2B5EF4-FFF2-40B4-BE49-F238E27FC236}">
                    <a16:creationId xmlns:a16="http://schemas.microsoft.com/office/drawing/2014/main" id="{5FC280B9-F952-8842-903F-CDBA2604F3E8}"/>
                  </a:ext>
                </a:extLst>
              </p:cNvPr>
              <p:cNvSpPr/>
              <p:nvPr/>
            </p:nvSpPr>
            <p:spPr>
              <a:xfrm>
                <a:off x="16998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1" name="Rectangle 310">
                <a:extLst>
                  <a:ext uri="{FF2B5EF4-FFF2-40B4-BE49-F238E27FC236}">
                    <a16:creationId xmlns:a16="http://schemas.microsoft.com/office/drawing/2014/main" id="{354D9C5F-C24C-1044-9776-23ABADDCD482}"/>
                  </a:ext>
                </a:extLst>
              </p:cNvPr>
              <p:cNvSpPr/>
              <p:nvPr/>
            </p:nvSpPr>
            <p:spPr>
              <a:xfrm>
                <a:off x="17950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2" name="Rectangle 311">
                <a:extLst>
                  <a:ext uri="{FF2B5EF4-FFF2-40B4-BE49-F238E27FC236}">
                    <a16:creationId xmlns:a16="http://schemas.microsoft.com/office/drawing/2014/main" id="{D56356B0-6A30-4E4E-8704-C2DC6389BB70}"/>
                  </a:ext>
                </a:extLst>
              </p:cNvPr>
              <p:cNvSpPr/>
              <p:nvPr/>
            </p:nvSpPr>
            <p:spPr>
              <a:xfrm>
                <a:off x="18903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3" name="Rectangle 312">
                <a:extLst>
                  <a:ext uri="{FF2B5EF4-FFF2-40B4-BE49-F238E27FC236}">
                    <a16:creationId xmlns:a16="http://schemas.microsoft.com/office/drawing/2014/main" id="{D7011E76-0597-8B43-9DD0-0B47142C96EA}"/>
                  </a:ext>
                </a:extLst>
              </p:cNvPr>
              <p:cNvSpPr/>
              <p:nvPr/>
            </p:nvSpPr>
            <p:spPr>
              <a:xfrm>
                <a:off x="19855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4" name="Rectangle 313">
                <a:extLst>
                  <a:ext uri="{FF2B5EF4-FFF2-40B4-BE49-F238E27FC236}">
                    <a16:creationId xmlns:a16="http://schemas.microsoft.com/office/drawing/2014/main" id="{48017F2D-188A-0542-986D-4D080406614F}"/>
                  </a:ext>
                </a:extLst>
              </p:cNvPr>
              <p:cNvSpPr/>
              <p:nvPr/>
            </p:nvSpPr>
            <p:spPr>
              <a:xfrm>
                <a:off x="20808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5" name="Rectangle 314">
                <a:extLst>
                  <a:ext uri="{FF2B5EF4-FFF2-40B4-BE49-F238E27FC236}">
                    <a16:creationId xmlns:a16="http://schemas.microsoft.com/office/drawing/2014/main" id="{433A6CAD-2286-0C45-88D2-FE54F1C3C205}"/>
                  </a:ext>
                </a:extLst>
              </p:cNvPr>
              <p:cNvSpPr/>
              <p:nvPr/>
            </p:nvSpPr>
            <p:spPr>
              <a:xfrm>
                <a:off x="21760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6" name="Rectangle 315">
                <a:extLst>
                  <a:ext uri="{FF2B5EF4-FFF2-40B4-BE49-F238E27FC236}">
                    <a16:creationId xmlns:a16="http://schemas.microsoft.com/office/drawing/2014/main" id="{8E6EB4D5-40AB-1444-8006-54A1BBBD1C8B}"/>
                  </a:ext>
                </a:extLst>
              </p:cNvPr>
              <p:cNvSpPr/>
              <p:nvPr/>
            </p:nvSpPr>
            <p:spPr>
              <a:xfrm>
                <a:off x="22713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7" name="Rectangle 316">
                <a:extLst>
                  <a:ext uri="{FF2B5EF4-FFF2-40B4-BE49-F238E27FC236}">
                    <a16:creationId xmlns:a16="http://schemas.microsoft.com/office/drawing/2014/main" id="{86AA4E07-573F-C44A-B65A-68B28D3465FE}"/>
                  </a:ext>
                </a:extLst>
              </p:cNvPr>
              <p:cNvSpPr/>
              <p:nvPr/>
            </p:nvSpPr>
            <p:spPr>
              <a:xfrm>
                <a:off x="23665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8" name="Rectangle 317">
                <a:extLst>
                  <a:ext uri="{FF2B5EF4-FFF2-40B4-BE49-F238E27FC236}">
                    <a16:creationId xmlns:a16="http://schemas.microsoft.com/office/drawing/2014/main" id="{8FA4E89F-E150-EB4B-B263-C7846512B56F}"/>
                  </a:ext>
                </a:extLst>
              </p:cNvPr>
              <p:cNvSpPr/>
              <p:nvPr/>
            </p:nvSpPr>
            <p:spPr>
              <a:xfrm>
                <a:off x="246180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19" name="Rectangle 318">
                <a:extLst>
                  <a:ext uri="{FF2B5EF4-FFF2-40B4-BE49-F238E27FC236}">
                    <a16:creationId xmlns:a16="http://schemas.microsoft.com/office/drawing/2014/main" id="{DAE8AB11-7A6D-7541-ADC6-B9BA1723EACE}"/>
                  </a:ext>
                </a:extLst>
              </p:cNvPr>
              <p:cNvSpPr/>
              <p:nvPr/>
            </p:nvSpPr>
            <p:spPr>
              <a:xfrm>
                <a:off x="2557051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0" name="Rectangle 319">
                <a:extLst>
                  <a:ext uri="{FF2B5EF4-FFF2-40B4-BE49-F238E27FC236}">
                    <a16:creationId xmlns:a16="http://schemas.microsoft.com/office/drawing/2014/main" id="{C4576AB0-52E5-CB49-BA0A-40CD2811F262}"/>
                  </a:ext>
                </a:extLst>
              </p:cNvPr>
              <p:cNvSpPr/>
              <p:nvPr/>
            </p:nvSpPr>
            <p:spPr>
              <a:xfrm>
                <a:off x="2652298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1" name="Rectangle 320">
                <a:extLst>
                  <a:ext uri="{FF2B5EF4-FFF2-40B4-BE49-F238E27FC236}">
                    <a16:creationId xmlns:a16="http://schemas.microsoft.com/office/drawing/2014/main" id="{D1409400-5957-C243-B5DB-E2928B1CE43F}"/>
                  </a:ext>
                </a:extLst>
              </p:cNvPr>
              <p:cNvSpPr/>
              <p:nvPr/>
            </p:nvSpPr>
            <p:spPr>
              <a:xfrm>
                <a:off x="274935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2" name="Rectangle 321">
                <a:extLst>
                  <a:ext uri="{FF2B5EF4-FFF2-40B4-BE49-F238E27FC236}">
                    <a16:creationId xmlns:a16="http://schemas.microsoft.com/office/drawing/2014/main" id="{60057E65-B016-BA4A-A8E4-F4EDD0EC5591}"/>
                  </a:ext>
                </a:extLst>
              </p:cNvPr>
              <p:cNvSpPr/>
              <p:nvPr/>
            </p:nvSpPr>
            <p:spPr>
              <a:xfrm>
                <a:off x="284460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3" name="Rectangle 322">
                <a:extLst>
                  <a:ext uri="{FF2B5EF4-FFF2-40B4-BE49-F238E27FC236}">
                    <a16:creationId xmlns:a16="http://schemas.microsoft.com/office/drawing/2014/main" id="{785E5300-5491-9F4E-BCB0-328CDC070842}"/>
                  </a:ext>
                </a:extLst>
              </p:cNvPr>
              <p:cNvSpPr/>
              <p:nvPr/>
            </p:nvSpPr>
            <p:spPr>
              <a:xfrm>
                <a:off x="293985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4" name="Rectangle 323">
                <a:extLst>
                  <a:ext uri="{FF2B5EF4-FFF2-40B4-BE49-F238E27FC236}">
                    <a16:creationId xmlns:a16="http://schemas.microsoft.com/office/drawing/2014/main" id="{68C084C8-33D9-F242-A85C-F7FC857E1325}"/>
                  </a:ext>
                </a:extLst>
              </p:cNvPr>
              <p:cNvSpPr/>
              <p:nvPr/>
            </p:nvSpPr>
            <p:spPr>
              <a:xfrm>
                <a:off x="303510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5" name="Rectangle 324">
                <a:extLst>
                  <a:ext uri="{FF2B5EF4-FFF2-40B4-BE49-F238E27FC236}">
                    <a16:creationId xmlns:a16="http://schemas.microsoft.com/office/drawing/2014/main" id="{A425EB8C-A8EA-FC41-9190-953902793C39}"/>
                  </a:ext>
                </a:extLst>
              </p:cNvPr>
              <p:cNvSpPr/>
              <p:nvPr/>
            </p:nvSpPr>
            <p:spPr>
              <a:xfrm>
                <a:off x="313035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6" name="Rectangle 325">
                <a:extLst>
                  <a:ext uri="{FF2B5EF4-FFF2-40B4-BE49-F238E27FC236}">
                    <a16:creationId xmlns:a16="http://schemas.microsoft.com/office/drawing/2014/main" id="{4940AEB9-2CC3-544D-956A-43D8CE4E9948}"/>
                  </a:ext>
                </a:extLst>
              </p:cNvPr>
              <p:cNvSpPr/>
              <p:nvPr/>
            </p:nvSpPr>
            <p:spPr>
              <a:xfrm>
                <a:off x="322560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7" name="Rectangle 326">
                <a:extLst>
                  <a:ext uri="{FF2B5EF4-FFF2-40B4-BE49-F238E27FC236}">
                    <a16:creationId xmlns:a16="http://schemas.microsoft.com/office/drawing/2014/main" id="{32719D5A-9799-644D-852B-53AE46CA37B5}"/>
                  </a:ext>
                </a:extLst>
              </p:cNvPr>
              <p:cNvSpPr/>
              <p:nvPr/>
            </p:nvSpPr>
            <p:spPr>
              <a:xfrm>
                <a:off x="332085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8" name="Rectangle 327">
                <a:extLst>
                  <a:ext uri="{FF2B5EF4-FFF2-40B4-BE49-F238E27FC236}">
                    <a16:creationId xmlns:a16="http://schemas.microsoft.com/office/drawing/2014/main" id="{9C71777C-2EC4-9943-B08B-6E2FE4F9961B}"/>
                  </a:ext>
                </a:extLst>
              </p:cNvPr>
              <p:cNvSpPr/>
              <p:nvPr/>
            </p:nvSpPr>
            <p:spPr>
              <a:xfrm>
                <a:off x="341610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29" name="Rectangle 328">
                <a:extLst>
                  <a:ext uri="{FF2B5EF4-FFF2-40B4-BE49-F238E27FC236}">
                    <a16:creationId xmlns:a16="http://schemas.microsoft.com/office/drawing/2014/main" id="{114A9C40-C360-7848-A030-AA1B75DFA3EF}"/>
                  </a:ext>
                </a:extLst>
              </p:cNvPr>
              <p:cNvSpPr/>
              <p:nvPr/>
            </p:nvSpPr>
            <p:spPr>
              <a:xfrm>
                <a:off x="351135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30" name="Rectangle 329">
                <a:extLst>
                  <a:ext uri="{FF2B5EF4-FFF2-40B4-BE49-F238E27FC236}">
                    <a16:creationId xmlns:a16="http://schemas.microsoft.com/office/drawing/2014/main" id="{BBAFB8EB-14D4-1C47-9365-690BFDD50F0B}"/>
                  </a:ext>
                </a:extLst>
              </p:cNvPr>
              <p:cNvSpPr/>
              <p:nvPr/>
            </p:nvSpPr>
            <p:spPr>
              <a:xfrm>
                <a:off x="360660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31" name="Rectangle 330">
                <a:extLst>
                  <a:ext uri="{FF2B5EF4-FFF2-40B4-BE49-F238E27FC236}">
                    <a16:creationId xmlns:a16="http://schemas.microsoft.com/office/drawing/2014/main" id="{876863B4-E4B6-024F-B155-9058C843EAB1}"/>
                  </a:ext>
                </a:extLst>
              </p:cNvPr>
              <p:cNvSpPr/>
              <p:nvPr/>
            </p:nvSpPr>
            <p:spPr>
              <a:xfrm>
                <a:off x="3701853" y="3307793"/>
                <a:ext cx="85344" cy="2286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48" name="Rectangle 347">
                <a:extLst>
                  <a:ext uri="{FF2B5EF4-FFF2-40B4-BE49-F238E27FC236}">
                    <a16:creationId xmlns:a16="http://schemas.microsoft.com/office/drawing/2014/main" id="{1CD75AB0-1594-D74E-82A1-EE7A6941BF69}"/>
                  </a:ext>
                </a:extLst>
              </p:cNvPr>
              <p:cNvSpPr/>
              <p:nvPr/>
            </p:nvSpPr>
            <p:spPr>
              <a:xfrm>
                <a:off x="3796792" y="3307793"/>
                <a:ext cx="219456" cy="228600"/>
              </a:xfrm>
              <a:prstGeom prst="rect">
                <a:avLst/>
              </a:prstGeom>
              <a:solidFill>
                <a:srgbClr val="73FB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49" name="Rectangle 348">
                <a:extLst>
                  <a:ext uri="{FF2B5EF4-FFF2-40B4-BE49-F238E27FC236}">
                    <a16:creationId xmlns:a16="http://schemas.microsoft.com/office/drawing/2014/main" id="{65C8B04C-49FF-674A-93C4-71C76B8483ED}"/>
                  </a:ext>
                </a:extLst>
              </p:cNvPr>
              <p:cNvSpPr/>
              <p:nvPr/>
            </p:nvSpPr>
            <p:spPr>
              <a:xfrm>
                <a:off x="4015259" y="3307793"/>
                <a:ext cx="914400" cy="228600"/>
              </a:xfrm>
              <a:prstGeom prst="rect">
                <a:avLst/>
              </a:prstGeom>
              <a:solidFill>
                <a:srgbClr val="0096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0" name="Rectangle 349">
                <a:extLst>
                  <a:ext uri="{FF2B5EF4-FFF2-40B4-BE49-F238E27FC236}">
                    <a16:creationId xmlns:a16="http://schemas.microsoft.com/office/drawing/2014/main" id="{031A17F7-7354-384E-8058-00495868DCBB}"/>
                  </a:ext>
                </a:extLst>
              </p:cNvPr>
              <p:cNvSpPr/>
              <p:nvPr/>
            </p:nvSpPr>
            <p:spPr>
              <a:xfrm>
                <a:off x="4925863" y="3307793"/>
                <a:ext cx="73152" cy="2286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86E6E1F4-323A-41AC-9BBD-F781B3C4D42A}"/>
                </a:ext>
              </a:extLst>
            </p:cNvPr>
            <p:cNvGrpSpPr/>
            <p:nvPr/>
          </p:nvGrpSpPr>
          <p:grpSpPr>
            <a:xfrm>
              <a:off x="451529" y="767684"/>
              <a:ext cx="1945086" cy="228600"/>
              <a:chOff x="332527" y="1277346"/>
              <a:chExt cx="1945086" cy="228600"/>
            </a:xfrm>
          </p:grpSpPr>
          <p:sp>
            <p:nvSpPr>
              <p:cNvPr id="351" name="Rectangle 350">
                <a:extLst>
                  <a:ext uri="{FF2B5EF4-FFF2-40B4-BE49-F238E27FC236}">
                    <a16:creationId xmlns:a16="http://schemas.microsoft.com/office/drawing/2014/main" id="{6D9B4BFE-05E3-034B-88CB-71335E9B5235}"/>
                  </a:ext>
                </a:extLst>
              </p:cNvPr>
              <p:cNvSpPr/>
              <p:nvPr/>
            </p:nvSpPr>
            <p:spPr>
              <a:xfrm>
                <a:off x="332527" y="1277346"/>
                <a:ext cx="54864" cy="2286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3" name="Rectangle 352">
                <a:extLst>
                  <a:ext uri="{FF2B5EF4-FFF2-40B4-BE49-F238E27FC236}">
                    <a16:creationId xmlns:a16="http://schemas.microsoft.com/office/drawing/2014/main" id="{69A6DD2A-25E4-0440-ABF2-FC49340CA5BE}"/>
                  </a:ext>
                </a:extLst>
              </p:cNvPr>
              <p:cNvSpPr/>
              <p:nvPr/>
            </p:nvSpPr>
            <p:spPr>
              <a:xfrm>
                <a:off x="381220" y="1277346"/>
                <a:ext cx="731520" cy="2286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4" name="Rectangle 353">
                <a:extLst>
                  <a:ext uri="{FF2B5EF4-FFF2-40B4-BE49-F238E27FC236}">
                    <a16:creationId xmlns:a16="http://schemas.microsoft.com/office/drawing/2014/main" id="{611EF73E-40A3-184E-B41A-F5E1D2E8C16F}"/>
                  </a:ext>
                </a:extLst>
              </p:cNvPr>
              <p:cNvSpPr/>
              <p:nvPr/>
            </p:nvSpPr>
            <p:spPr>
              <a:xfrm>
                <a:off x="1112919" y="1277346"/>
                <a:ext cx="524256" cy="228600"/>
              </a:xfrm>
              <a:prstGeom prst="rect">
                <a:avLst/>
              </a:prstGeom>
              <a:solidFill>
                <a:srgbClr val="0432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5" name="Rectangle 354">
                <a:extLst>
                  <a:ext uri="{FF2B5EF4-FFF2-40B4-BE49-F238E27FC236}">
                    <a16:creationId xmlns:a16="http://schemas.microsoft.com/office/drawing/2014/main" id="{BD38B845-BC09-CB4F-8454-C4B35FA26239}"/>
                  </a:ext>
                </a:extLst>
              </p:cNvPr>
              <p:cNvSpPr/>
              <p:nvPr/>
            </p:nvSpPr>
            <p:spPr>
              <a:xfrm>
                <a:off x="1637354" y="1277346"/>
                <a:ext cx="591312" cy="228600"/>
              </a:xfrm>
              <a:prstGeom prst="rect">
                <a:avLst/>
              </a:prstGeom>
              <a:solidFill>
                <a:srgbClr val="FF40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6" name="Rectangle 355">
                <a:extLst>
                  <a:ext uri="{FF2B5EF4-FFF2-40B4-BE49-F238E27FC236}">
                    <a16:creationId xmlns:a16="http://schemas.microsoft.com/office/drawing/2014/main" id="{D646CF31-C5F9-CE40-8F41-4F0C9A747AA9}"/>
                  </a:ext>
                </a:extLst>
              </p:cNvPr>
              <p:cNvSpPr/>
              <p:nvPr/>
            </p:nvSpPr>
            <p:spPr>
              <a:xfrm>
                <a:off x="2228845" y="1277346"/>
                <a:ext cx="48768" cy="2286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1DD9829-8985-46E3-89F5-4393B178712A}"/>
                </a:ext>
              </a:extLst>
            </p:cNvPr>
            <p:cNvGrpSpPr/>
            <p:nvPr/>
          </p:nvGrpSpPr>
          <p:grpSpPr>
            <a:xfrm>
              <a:off x="5516385" y="2341479"/>
              <a:ext cx="795203" cy="246221"/>
              <a:chOff x="6764374" y="2242472"/>
              <a:chExt cx="795203" cy="246221"/>
            </a:xfrm>
          </p:grpSpPr>
          <p:sp>
            <p:nvSpPr>
              <p:cNvPr id="357" name="Rectangle 356">
                <a:extLst>
                  <a:ext uri="{FF2B5EF4-FFF2-40B4-BE49-F238E27FC236}">
                    <a16:creationId xmlns:a16="http://schemas.microsoft.com/office/drawing/2014/main" id="{3C506736-E249-F24C-B004-48C7FC547291}"/>
                  </a:ext>
                </a:extLst>
              </p:cNvPr>
              <p:cNvSpPr/>
              <p:nvPr/>
            </p:nvSpPr>
            <p:spPr>
              <a:xfrm>
                <a:off x="6764374" y="2246710"/>
                <a:ext cx="237744" cy="23774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358" name="TextBox 357">
                <a:extLst>
                  <a:ext uri="{FF2B5EF4-FFF2-40B4-BE49-F238E27FC236}">
                    <a16:creationId xmlns:a16="http://schemas.microsoft.com/office/drawing/2014/main" id="{0CC6B486-A6BC-5E47-A566-008FFBBF44A1}"/>
                  </a:ext>
                </a:extLst>
              </p:cNvPr>
              <p:cNvSpPr txBox="1"/>
              <p:nvPr/>
            </p:nvSpPr>
            <p:spPr>
              <a:xfrm>
                <a:off x="6986984" y="2242472"/>
                <a:ext cx="5725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 aa</a:t>
                </a:r>
              </a:p>
            </p:txBody>
          </p:sp>
        </p:grp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8DDBC149-17D4-8043-9BA1-5269F971EB96}"/>
                </a:ext>
              </a:extLst>
            </p:cNvPr>
            <p:cNvSpPr txBox="1"/>
            <p:nvPr/>
          </p:nvSpPr>
          <p:spPr>
            <a:xfrm>
              <a:off x="1110262" y="1055575"/>
              <a:ext cx="44775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ontig 7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20,494 to 10,814 of 1,721,375 total =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btelomeric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location)</a:t>
              </a: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5DF8F4D0-EB5D-564F-ABFA-7118C9AEFB66}"/>
                </a:ext>
              </a:extLst>
            </p:cNvPr>
            <p:cNvSpPr txBox="1"/>
            <p:nvPr/>
          </p:nvSpPr>
          <p:spPr>
            <a:xfrm>
              <a:off x="1107197" y="1638998"/>
              <a:ext cx="47981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ontig 7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707,483 to 1,714,505 of 1,721,375 total =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btelomeric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location)</a:t>
              </a: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842C41CA-CAA0-944F-BDFB-FC6FCEDA3BED}"/>
                </a:ext>
              </a:extLst>
            </p:cNvPr>
            <p:cNvSpPr txBox="1"/>
            <p:nvPr/>
          </p:nvSpPr>
          <p:spPr>
            <a:xfrm>
              <a:off x="1095216" y="2184927"/>
              <a:ext cx="3789820" cy="235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ontig 14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142,266 to 1,147,734 of 1,261,352 total)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171A0D39-1074-6045-93DF-F7CD286B07A6}"/>
                </a:ext>
              </a:extLst>
            </p:cNvPr>
            <p:cNvSpPr txBox="1"/>
            <p:nvPr/>
          </p:nvSpPr>
          <p:spPr>
            <a:xfrm>
              <a:off x="1015513" y="552615"/>
              <a:ext cx="35830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ontig 4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183,464 to 1,185,902 of 2,095,026 total)</a:t>
              </a:r>
            </a:p>
          </p:txBody>
        </p:sp>
      </p:grpSp>
      <p:sp>
        <p:nvSpPr>
          <p:cNvPr id="5" name="Rectangle 3">
            <a:extLst>
              <a:ext uri="{FF2B5EF4-FFF2-40B4-BE49-F238E27FC236}">
                <a16:creationId xmlns:a16="http://schemas.microsoft.com/office/drawing/2014/main" id="{96050657-E3F1-48B8-ACFC-2374102DE3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1275" y="3404889"/>
            <a:ext cx="5245347" cy="123110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sensus tandem repeat sequence in each protein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gAls2229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(35 aa)  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PT___T_TWTGS___TTT____PG___TV____</a:t>
            </a:r>
            <a:r>
              <a:rPr kumimoji="0" lang="en-US" altLang="en-US" sz="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gAls3259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5 aa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P_PTTT_T_TWTG______T____PG_T_TV____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gAls3330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5 aa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PTP_TTIT_TWTGT_TTT_T__A__GGT_TVVV_V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 Consensus (36 aa)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VTTT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WS_S___T_T_T__P__T__V___E</a:t>
            </a: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r Consensus (36 aa)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NPT_T_T_________T_T_______TD______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pCoCm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Consensus (36 aa)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PT_T_T__WTG____T_T_T__PG_TD_V_V__</a:t>
            </a: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7FEA7734-0AF1-480F-9C37-94C4B1BF7D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4743635"/>
              </p:ext>
            </p:extLst>
          </p:nvPr>
        </p:nvGraphicFramePr>
        <p:xfrm>
          <a:off x="1658947" y="5299545"/>
          <a:ext cx="5570004" cy="100584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28334">
                  <a:extLst>
                    <a:ext uri="{9D8B030D-6E8A-4147-A177-3AD203B41FA5}">
                      <a16:colId xmlns:a16="http://schemas.microsoft.com/office/drawing/2014/main" val="2131190332"/>
                    </a:ext>
                  </a:extLst>
                </a:gridCol>
                <a:gridCol w="928334">
                  <a:extLst>
                    <a:ext uri="{9D8B030D-6E8A-4147-A177-3AD203B41FA5}">
                      <a16:colId xmlns:a16="http://schemas.microsoft.com/office/drawing/2014/main" val="2509173655"/>
                    </a:ext>
                  </a:extLst>
                </a:gridCol>
                <a:gridCol w="928334">
                  <a:extLst>
                    <a:ext uri="{9D8B030D-6E8A-4147-A177-3AD203B41FA5}">
                      <a16:colId xmlns:a16="http://schemas.microsoft.com/office/drawing/2014/main" val="1583704248"/>
                    </a:ext>
                  </a:extLst>
                </a:gridCol>
                <a:gridCol w="928334">
                  <a:extLst>
                    <a:ext uri="{9D8B030D-6E8A-4147-A177-3AD203B41FA5}">
                      <a16:colId xmlns:a16="http://schemas.microsoft.com/office/drawing/2014/main" val="2936704474"/>
                    </a:ext>
                  </a:extLst>
                </a:gridCol>
                <a:gridCol w="928334">
                  <a:extLst>
                    <a:ext uri="{9D8B030D-6E8A-4147-A177-3AD203B41FA5}">
                      <a16:colId xmlns:a16="http://schemas.microsoft.com/office/drawing/2014/main" val="2959378178"/>
                    </a:ext>
                  </a:extLst>
                </a:gridCol>
                <a:gridCol w="928334">
                  <a:extLst>
                    <a:ext uri="{9D8B030D-6E8A-4147-A177-3AD203B41FA5}">
                      <a16:colId xmlns:a16="http://schemas.microsoft.com/office/drawing/2014/main" val="2445785930"/>
                    </a:ext>
                  </a:extLst>
                </a:gridCol>
              </a:tblGrid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MgAls673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</a:rPr>
                        <a:t>MgAls2302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MgAls3259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MgAls3330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828127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MgAls673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936531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 err="1">
                          <a:effectLst/>
                        </a:rPr>
                        <a:t>MgAls2302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341924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MgAls3259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225445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MgAls3330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4973000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8811084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87AC59A7-4AB2-45F2-9A2C-D24B2A2833F1}"/>
              </a:ext>
            </a:extLst>
          </p:cNvPr>
          <p:cNvSpPr txBox="1"/>
          <p:nvPr/>
        </p:nvSpPr>
        <p:spPr>
          <a:xfrm>
            <a:off x="1863959" y="5047655"/>
            <a:ext cx="5245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ercent identity values for comparisons between NT-Als sequences in each protein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2EAFE84B-6625-423B-8EA8-32F570C71C2F}"/>
              </a:ext>
            </a:extLst>
          </p:cNvPr>
          <p:cNvSpPr txBox="1"/>
          <p:nvPr/>
        </p:nvSpPr>
        <p:spPr>
          <a:xfrm>
            <a:off x="375474" y="33656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2C9BCE71-55BE-4919-9A59-19E92ABE201F}"/>
              </a:ext>
            </a:extLst>
          </p:cNvPr>
          <p:cNvSpPr txBox="1"/>
          <p:nvPr/>
        </p:nvSpPr>
        <p:spPr>
          <a:xfrm>
            <a:off x="1445240" y="33154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C9721E9C-D132-468B-BC09-2D375BE67165}"/>
              </a:ext>
            </a:extLst>
          </p:cNvPr>
          <p:cNvSpPr txBox="1"/>
          <p:nvPr/>
        </p:nvSpPr>
        <p:spPr>
          <a:xfrm>
            <a:off x="1553098" y="501687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9541590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ED09CD6-DC73-47F5-8024-2A4159B4A840}"/>
              </a:ext>
            </a:extLst>
          </p:cNvPr>
          <p:cNvSpPr txBox="1"/>
          <p:nvPr/>
        </p:nvSpPr>
        <p:spPr>
          <a:xfrm>
            <a:off x="559920" y="605120"/>
            <a:ext cx="802478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|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illiermondi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feature summary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ine drawings to illustrate the basic features of the Als proteins predicted from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illiermondi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sequence and validated by PCR amplification/Sanger sequencing. Genome assembl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M694215v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ordinates were referenced above each drawing. A color-coding key and scale bar are shown. The red region in each drawing corresponded to the NT-Als domain; the “+” designation referred to inclusion of sequences C-terminal to NT-Als. NT-Als + ended where repeated sequences or Ser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ch sequences began, and in some proteins, included what was called the 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ch) domain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proteins (reviewed in 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yer and Cota, 201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When present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gA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ndemly repeated sequences were highly conserved and 35 aa in length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cent identity values for comparisons among the NT-Als sequences for each protein calculat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deira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included for reference because its crystallographic structure is known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 et al., 2014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7435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3</TotalTime>
  <Words>479</Words>
  <Application>Microsoft Office PowerPoint</Application>
  <PresentationFormat>On-screen Show (4:3)</PresentationFormat>
  <Paragraphs>6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ois Hoyer</cp:lastModifiedBy>
  <cp:revision>15</cp:revision>
  <cp:lastPrinted>2021-08-30T15:45:04Z</cp:lastPrinted>
  <dcterms:created xsi:type="dcterms:W3CDTF">2018-02-24T12:42:49Z</dcterms:created>
  <dcterms:modified xsi:type="dcterms:W3CDTF">2021-10-03T15:00:57Z</dcterms:modified>
</cp:coreProperties>
</file>